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375" r:id="rId2"/>
    <p:sldId id="376" r:id="rId3"/>
    <p:sldId id="277" r:id="rId4"/>
    <p:sldId id="276" r:id="rId5"/>
    <p:sldId id="377" r:id="rId6"/>
    <p:sldId id="261" r:id="rId7"/>
    <p:sldId id="256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E26410C-C204-9287-AEB3-ED99C2491191}" name="Balestra, Tommaso" initials="BT" userId="S::BALESTRAT@CHOP.EDU::cbe765c0-94da-4654-aea2-660bfc9f4b09" providerId="AD"/>
  <p188:author id="{8AC12456-D567-3C77-CB71-17DD4F28F36F}" name="Niswander, Lisa M" initials="LN" userId="S::NISWANDERL@CHOP.EDU::4492e956-a81e-4093-89f6-0ab72a0ce276" providerId="AD"/>
  <p188:author id="{1D84FB7C-37BF-89CC-BED3-EF375E667D5A}" name="Niswander, Lisa M" initials="LN" userId="S::niswanderl@chop.edu::4492e956-a81e-4093-89f6-0ab72a0ce276" providerId="AD"/>
  <p188:author id="{7F288E91-6E79-B32F-8DC8-9C904FC9BAE8}" name="Tommaso Balestra" initials="TB" userId="0981a8c328eb01cc" providerId="Windows Live"/>
  <p188:author id="{0E8F44C9-802D-04AC-4639-03791DB0D52E}" name="sarah k tasian, md" initials="skt" userId="sarah k tasian, md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914FF"/>
    <a:srgbClr val="9437FF"/>
    <a:srgbClr val="F1D5D5"/>
    <a:srgbClr val="E1A9AA"/>
    <a:srgbClr val="FFE79D"/>
    <a:srgbClr val="FFE79E"/>
    <a:srgbClr val="FFFFFF"/>
    <a:srgbClr val="C39BEB"/>
    <a:srgbClr val="7BD0E4"/>
    <a:srgbClr val="B4CD8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F200C86-7DDA-4F23-9373-C0D1821E397A}" v="6" dt="2024-10-23T20:09:17.684"/>
    <p1510:client id="{AA0487CB-F47C-4F3C-AE02-25262A8C2F0F}" v="7" dt="2024-10-25T16:39:17.89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84" autoAdjust="0"/>
    <p:restoredTop sz="95771" autoAdjust="0"/>
  </p:normalViewPr>
  <p:slideViewPr>
    <p:cSldViewPr snapToGrid="0" snapToObjects="1">
      <p:cViewPr varScale="1">
        <p:scale>
          <a:sx n="91" d="100"/>
          <a:sy n="91" d="100"/>
        </p:scale>
        <p:origin x="324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ommaso Balestra" userId="EyCEVidHREH6+Tuc9W7jYMbpLb0786HMXMqGjilZs20=" providerId="None" clId="Web-{2F200C86-7DDA-4F23-9373-C0D1821E397A}"/>
    <pc:docChg chg="addSld delSld modSld">
      <pc:chgData name="Tommaso Balestra" userId="EyCEVidHREH6+Tuc9W7jYMbpLb0786HMXMqGjilZs20=" providerId="None" clId="Web-{2F200C86-7DDA-4F23-9373-C0D1821E397A}" dt="2024-10-23T20:09:17.278" v="3" actId="20577"/>
      <pc:docMkLst>
        <pc:docMk/>
      </pc:docMkLst>
      <pc:sldChg chg="modSp add del">
        <pc:chgData name="Tommaso Balestra" userId="EyCEVidHREH6+Tuc9W7jYMbpLb0786HMXMqGjilZs20=" providerId="None" clId="Web-{2F200C86-7DDA-4F23-9373-C0D1821E397A}" dt="2024-10-23T20:09:17.278" v="3" actId="20577"/>
        <pc:sldMkLst>
          <pc:docMk/>
          <pc:sldMk cId="120071280" sldId="256"/>
        </pc:sldMkLst>
        <pc:spChg chg="mod">
          <ac:chgData name="Tommaso Balestra" userId="EyCEVidHREH6+Tuc9W7jYMbpLb0786HMXMqGjilZs20=" providerId="None" clId="Web-{2F200C86-7DDA-4F23-9373-C0D1821E397A}" dt="2024-10-23T20:09:17.278" v="3" actId="20577"/>
          <ac:spMkLst>
            <pc:docMk/>
            <pc:sldMk cId="120071280" sldId="256"/>
            <ac:spMk id="19" creationId="{E472F014-0411-C458-30F4-D5DB6FD3B38F}"/>
          </ac:spMkLst>
        </pc:spChg>
      </pc:sldChg>
    </pc:docChg>
  </pc:docChgLst>
  <pc:docChgLst>
    <pc:chgData name="Tommaso Balestra" userId="EyCEVidHREH6+Tuc9W7jYMbpLb0786HMXMqGjilZs20=" providerId="None" clId="Web-{AA0487CB-F47C-4F3C-AE02-25262A8C2F0F}"/>
    <pc:docChg chg="addSld delSld modSld">
      <pc:chgData name="Tommaso Balestra" userId="EyCEVidHREH6+Tuc9W7jYMbpLb0786HMXMqGjilZs20=" providerId="None" clId="Web-{AA0487CB-F47C-4F3C-AE02-25262A8C2F0F}" dt="2024-10-25T16:39:17.329" v="4" actId="20577"/>
      <pc:docMkLst>
        <pc:docMk/>
      </pc:docMkLst>
      <pc:sldChg chg="modSp add del">
        <pc:chgData name="Tommaso Balestra" userId="EyCEVidHREH6+Tuc9W7jYMbpLb0786HMXMqGjilZs20=" providerId="None" clId="Web-{AA0487CB-F47C-4F3C-AE02-25262A8C2F0F}" dt="2024-10-25T16:39:17.329" v="4" actId="20577"/>
        <pc:sldMkLst>
          <pc:docMk/>
          <pc:sldMk cId="120071280" sldId="256"/>
        </pc:sldMkLst>
        <pc:spChg chg="mod">
          <ac:chgData name="Tommaso Balestra" userId="EyCEVidHREH6+Tuc9W7jYMbpLb0786HMXMqGjilZs20=" providerId="None" clId="Web-{AA0487CB-F47C-4F3C-AE02-25262A8C2F0F}" dt="2024-10-25T16:39:17.329" v="4" actId="20577"/>
          <ac:spMkLst>
            <pc:docMk/>
            <pc:sldMk cId="120071280" sldId="256"/>
            <ac:spMk id="19" creationId="{E472F014-0411-C458-30F4-D5DB6FD3B38F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B52945-405A-E64B-9E6B-C6521590EE0F}" type="datetimeFigureOut">
              <a:rPr lang="en-US" smtClean="0"/>
              <a:t>11/5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431E7C-7562-5B4D-90AB-9587345B0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215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dirty="0">
              <a:effectLst/>
              <a:latin typeface="Calibri"/>
              <a:ea typeface="Times New Roman" panose="02020603050405020304" pitchFamily="18" charset="0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79E938-0F74-4542-9003-C8E8DB3E7E7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4655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79E938-0F74-4542-9003-C8E8DB3E7E7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68262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endParaRPr lang="en-US" b="1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79E938-0F74-4542-9003-C8E8DB3E7E7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09161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475D4-7BC7-4BDA-A8D4-9521634912E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0305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B475D4-7BC7-4BDA-A8D4-9521634912E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63179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endParaRPr lang="en-US" b="1" dirty="0">
              <a:cs typeface="Calibri"/>
            </a:endParaRPr>
          </a:p>
          <a:p>
            <a:pPr>
              <a:defRPr/>
            </a:pP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431E7C-7562-5B4D-90AB-9587345B0AF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75997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9C3C26-A68C-41C4-AA2F-A3F7CB552AF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9923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7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17" indent="0" algn="ctr">
              <a:buNone/>
              <a:defRPr sz="1500"/>
            </a:lvl2pPr>
            <a:lvl3pPr marL="685832" indent="0" algn="ctr">
              <a:buNone/>
              <a:defRPr sz="1350"/>
            </a:lvl3pPr>
            <a:lvl4pPr marL="1028749" indent="0" algn="ctr">
              <a:buNone/>
              <a:defRPr sz="1200"/>
            </a:lvl4pPr>
            <a:lvl5pPr marL="1371664" indent="0" algn="ctr">
              <a:buNone/>
              <a:defRPr sz="1200"/>
            </a:lvl5pPr>
            <a:lvl6pPr marL="1714580" indent="0" algn="ctr">
              <a:buNone/>
              <a:defRPr sz="1200"/>
            </a:lvl6pPr>
            <a:lvl7pPr marL="2057496" indent="0" algn="ctr">
              <a:buNone/>
              <a:defRPr sz="1200"/>
            </a:lvl7pPr>
            <a:lvl8pPr marL="2400412" indent="0" algn="ctr">
              <a:buNone/>
              <a:defRPr sz="1200"/>
            </a:lvl8pPr>
            <a:lvl9pPr marL="2743329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579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918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7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7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657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029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6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90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1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3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8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9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41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3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815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296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9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4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7" indent="0">
              <a:buNone/>
              <a:defRPr sz="1500" b="1"/>
            </a:lvl2pPr>
            <a:lvl3pPr marL="685832" indent="0">
              <a:buNone/>
              <a:defRPr sz="1350" b="1"/>
            </a:lvl3pPr>
            <a:lvl4pPr marL="1028749" indent="0">
              <a:buNone/>
              <a:defRPr sz="1200" b="1"/>
            </a:lvl4pPr>
            <a:lvl5pPr marL="1371664" indent="0">
              <a:buNone/>
              <a:defRPr sz="1200" b="1"/>
            </a:lvl5pPr>
            <a:lvl6pPr marL="1714580" indent="0">
              <a:buNone/>
              <a:defRPr sz="1200" b="1"/>
            </a:lvl6pPr>
            <a:lvl7pPr marL="2057496" indent="0">
              <a:buNone/>
              <a:defRPr sz="1200" b="1"/>
            </a:lvl7pPr>
            <a:lvl8pPr marL="2400412" indent="0">
              <a:buNone/>
              <a:defRPr sz="1200" b="1"/>
            </a:lvl8pPr>
            <a:lvl9pPr marL="2743329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241554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7" indent="0">
              <a:buNone/>
              <a:defRPr sz="1500" b="1"/>
            </a:lvl2pPr>
            <a:lvl3pPr marL="685832" indent="0">
              <a:buNone/>
              <a:defRPr sz="1350" b="1"/>
            </a:lvl3pPr>
            <a:lvl4pPr marL="1028749" indent="0">
              <a:buNone/>
              <a:defRPr sz="1200" b="1"/>
            </a:lvl4pPr>
            <a:lvl5pPr marL="1371664" indent="0">
              <a:buNone/>
              <a:defRPr sz="1200" b="1"/>
            </a:lvl5pPr>
            <a:lvl6pPr marL="1714580" indent="0">
              <a:buNone/>
              <a:defRPr sz="1200" b="1"/>
            </a:lvl6pPr>
            <a:lvl7pPr marL="2057496" indent="0">
              <a:buNone/>
              <a:defRPr sz="1200" b="1"/>
            </a:lvl7pPr>
            <a:lvl8pPr marL="2400412" indent="0">
              <a:buNone/>
              <a:defRPr sz="1200" b="1"/>
            </a:lvl8pPr>
            <a:lvl9pPr marL="2743329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008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6072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145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72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7" indent="0">
              <a:buNone/>
              <a:defRPr sz="1050"/>
            </a:lvl2pPr>
            <a:lvl3pPr marL="685832" indent="0">
              <a:buNone/>
              <a:defRPr sz="900"/>
            </a:lvl3pPr>
            <a:lvl4pPr marL="1028749" indent="0">
              <a:buNone/>
              <a:defRPr sz="750"/>
            </a:lvl4pPr>
            <a:lvl5pPr marL="1371664" indent="0">
              <a:buNone/>
              <a:defRPr sz="750"/>
            </a:lvl5pPr>
            <a:lvl6pPr marL="1714580" indent="0">
              <a:buNone/>
              <a:defRPr sz="750"/>
            </a:lvl6pPr>
            <a:lvl7pPr marL="2057496" indent="0">
              <a:buNone/>
              <a:defRPr sz="750"/>
            </a:lvl7pPr>
            <a:lvl8pPr marL="2400412" indent="0">
              <a:buNone/>
              <a:defRPr sz="750"/>
            </a:lvl8pPr>
            <a:lvl9pPr marL="2743329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507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72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17" indent="0">
              <a:buNone/>
              <a:defRPr sz="2100"/>
            </a:lvl2pPr>
            <a:lvl3pPr marL="685832" indent="0">
              <a:buNone/>
              <a:defRPr sz="1800"/>
            </a:lvl3pPr>
            <a:lvl4pPr marL="1028749" indent="0">
              <a:buNone/>
              <a:defRPr sz="1500"/>
            </a:lvl4pPr>
            <a:lvl5pPr marL="1371664" indent="0">
              <a:buNone/>
              <a:defRPr sz="1500"/>
            </a:lvl5pPr>
            <a:lvl6pPr marL="1714580" indent="0">
              <a:buNone/>
              <a:defRPr sz="1500"/>
            </a:lvl6pPr>
            <a:lvl7pPr marL="2057496" indent="0">
              <a:buNone/>
              <a:defRPr sz="1500"/>
            </a:lvl7pPr>
            <a:lvl8pPr marL="2400412" indent="0">
              <a:buNone/>
              <a:defRPr sz="1500"/>
            </a:lvl8pPr>
            <a:lvl9pPr marL="2743329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7" indent="0">
              <a:buNone/>
              <a:defRPr sz="1050"/>
            </a:lvl2pPr>
            <a:lvl3pPr marL="685832" indent="0">
              <a:buNone/>
              <a:defRPr sz="900"/>
            </a:lvl3pPr>
            <a:lvl4pPr marL="1028749" indent="0">
              <a:buNone/>
              <a:defRPr sz="750"/>
            </a:lvl4pPr>
            <a:lvl5pPr marL="1371664" indent="0">
              <a:buNone/>
              <a:defRPr sz="750"/>
            </a:lvl5pPr>
            <a:lvl6pPr marL="1714580" indent="0">
              <a:buNone/>
              <a:defRPr sz="750"/>
            </a:lvl6pPr>
            <a:lvl7pPr marL="2057496" indent="0">
              <a:buNone/>
              <a:defRPr sz="750"/>
            </a:lvl7pPr>
            <a:lvl8pPr marL="2400412" indent="0">
              <a:buNone/>
              <a:defRPr sz="750"/>
            </a:lvl8pPr>
            <a:lvl9pPr marL="2743329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671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9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9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13AE81-D46C-B946-BE64-A39AD0A9943B}" type="datetimeFigureOut">
              <a:rPr lang="en-US" smtClean="0"/>
              <a:t>11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9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9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0A2E2-ECE6-E24F-B609-FA6502A66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218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3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8" indent="-171458" algn="l" defTabSz="68583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74" indent="-171458" algn="l" defTabSz="6858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89" indent="-171458" algn="l" defTabSz="6858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206" indent="-171458" algn="l" defTabSz="6858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123" indent="-171458" algn="l" defTabSz="6858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038" indent="-171458" algn="l" defTabSz="6858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955" indent="-171458" algn="l" defTabSz="6858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870" indent="-171458" algn="l" defTabSz="6858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786" indent="-171458" algn="l" defTabSz="68583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17" algn="l" defTabSz="6858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32" algn="l" defTabSz="6858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49" algn="l" defTabSz="6858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4" algn="l" defTabSz="6858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80" algn="l" defTabSz="6858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96" algn="l" defTabSz="6858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412" algn="l" defTabSz="6858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329" algn="l" defTabSz="68583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oleObject" Target="../embeddings/oleObject2.bin"/><Relationship Id="rId18" Type="http://schemas.openxmlformats.org/officeDocument/2006/relationships/image" Target="../media/image9.emf"/><Relationship Id="rId26" Type="http://schemas.openxmlformats.org/officeDocument/2006/relationships/oleObject" Target="../embeddings/oleObject8.bin"/><Relationship Id="rId3" Type="http://schemas.openxmlformats.org/officeDocument/2006/relationships/image" Target="../media/image1.png"/><Relationship Id="rId21" Type="http://schemas.openxmlformats.org/officeDocument/2006/relationships/oleObject" Target="../embeddings/oleObject6.bin"/><Relationship Id="rId7" Type="http://schemas.openxmlformats.org/officeDocument/2006/relationships/image" Target="../media/image3.png"/><Relationship Id="rId12" Type="http://schemas.openxmlformats.org/officeDocument/2006/relationships/image" Target="../media/image6.emf"/><Relationship Id="rId17" Type="http://schemas.openxmlformats.org/officeDocument/2006/relationships/oleObject" Target="../embeddings/oleObject4.bin"/><Relationship Id="rId25" Type="http://schemas.openxmlformats.org/officeDocument/2006/relationships/image" Target="../media/image13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emf"/><Relationship Id="rId20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oleObject" Target="../embeddings/oleObject1.bin"/><Relationship Id="rId24" Type="http://schemas.openxmlformats.org/officeDocument/2006/relationships/image" Target="../media/image12.emf"/><Relationship Id="rId5" Type="http://schemas.openxmlformats.org/officeDocument/2006/relationships/image" Target="../media/image2.png"/><Relationship Id="rId15" Type="http://schemas.openxmlformats.org/officeDocument/2006/relationships/oleObject" Target="../embeddings/oleObject3.bin"/><Relationship Id="rId23" Type="http://schemas.openxmlformats.org/officeDocument/2006/relationships/oleObject" Target="../embeddings/oleObject7.bin"/><Relationship Id="rId28" Type="http://schemas.openxmlformats.org/officeDocument/2006/relationships/image" Target="../media/image15.emf"/><Relationship Id="rId10" Type="http://schemas.openxmlformats.org/officeDocument/2006/relationships/image" Target="../media/image5.tiff"/><Relationship Id="rId19" Type="http://schemas.openxmlformats.org/officeDocument/2006/relationships/oleObject" Target="../embeddings/oleObject5.bin"/><Relationship Id="rId4" Type="http://schemas.microsoft.com/office/2007/relationships/hdphoto" Target="../media/hdphoto1.wdp"/><Relationship Id="rId9" Type="http://schemas.openxmlformats.org/officeDocument/2006/relationships/image" Target="../media/image4.tiff"/><Relationship Id="rId14" Type="http://schemas.openxmlformats.org/officeDocument/2006/relationships/image" Target="../media/image7.emf"/><Relationship Id="rId22" Type="http://schemas.openxmlformats.org/officeDocument/2006/relationships/image" Target="../media/image11.emf"/><Relationship Id="rId27" Type="http://schemas.openxmlformats.org/officeDocument/2006/relationships/image" Target="../media/image14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2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e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0" Type="http://schemas.openxmlformats.org/officeDocument/2006/relationships/image" Target="../media/image20.emf"/><Relationship Id="rId4" Type="http://schemas.openxmlformats.org/officeDocument/2006/relationships/image" Target="../media/image17.emf"/><Relationship Id="rId9" Type="http://schemas.openxmlformats.org/officeDocument/2006/relationships/oleObject" Target="../embeddings/oleObject12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oleObject" Target="../embeddings/oleObject14.bin"/><Relationship Id="rId7" Type="http://schemas.openxmlformats.org/officeDocument/2006/relationships/oleObject" Target="../embeddings/oleObject16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emf"/><Relationship Id="rId5" Type="http://schemas.openxmlformats.org/officeDocument/2006/relationships/oleObject" Target="../embeddings/oleObject15.bin"/><Relationship Id="rId10" Type="http://schemas.openxmlformats.org/officeDocument/2006/relationships/image" Target="../media/image25.emf"/><Relationship Id="rId4" Type="http://schemas.openxmlformats.org/officeDocument/2006/relationships/image" Target="../media/image22.emf"/><Relationship Id="rId9" Type="http://schemas.openxmlformats.org/officeDocument/2006/relationships/oleObject" Target="../embeddings/oleObject17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3" Type="http://schemas.openxmlformats.org/officeDocument/2006/relationships/oleObject" Target="../embeddings/oleObject18.bin"/><Relationship Id="rId7" Type="http://schemas.openxmlformats.org/officeDocument/2006/relationships/oleObject" Target="../embeddings/oleObject20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emf"/><Relationship Id="rId5" Type="http://schemas.openxmlformats.org/officeDocument/2006/relationships/oleObject" Target="../embeddings/oleObject19.bin"/><Relationship Id="rId10" Type="http://schemas.openxmlformats.org/officeDocument/2006/relationships/image" Target="../media/image30.emf"/><Relationship Id="rId4" Type="http://schemas.openxmlformats.org/officeDocument/2006/relationships/image" Target="../media/image27.emf"/><Relationship Id="rId9" Type="http://schemas.openxmlformats.org/officeDocument/2006/relationships/oleObject" Target="../embeddings/oleObject21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2.bin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emf"/><Relationship Id="rId5" Type="http://schemas.openxmlformats.org/officeDocument/2006/relationships/oleObject" Target="../embeddings/oleObject23.bin"/><Relationship Id="rId4" Type="http://schemas.openxmlformats.org/officeDocument/2006/relationships/image" Target="../media/image3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TextBox 133">
            <a:extLst>
              <a:ext uri="{FF2B5EF4-FFF2-40B4-BE49-F238E27FC236}">
                <a16:creationId xmlns:a16="http://schemas.microsoft.com/office/drawing/2014/main" id="{00D7B6D8-7ABA-B49D-9965-A5C1E5D0C15B}"/>
              </a:ext>
            </a:extLst>
          </p:cNvPr>
          <p:cNvSpPr txBox="1"/>
          <p:nvPr/>
        </p:nvSpPr>
        <p:spPr>
          <a:xfrm>
            <a:off x="43544" y="54426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47693799-FEF0-C01F-7407-526EE032A884}"/>
              </a:ext>
            </a:extLst>
          </p:cNvPr>
          <p:cNvGrpSpPr/>
          <p:nvPr/>
        </p:nvGrpSpPr>
        <p:grpSpPr>
          <a:xfrm>
            <a:off x="-29963" y="346300"/>
            <a:ext cx="7003519" cy="7139881"/>
            <a:chOff x="-29963" y="346300"/>
            <a:chExt cx="7003519" cy="7139881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60A980BC-81CD-475C-81B3-C5A0FCA4B208}"/>
                </a:ext>
              </a:extLst>
            </p:cNvPr>
            <p:cNvSpPr txBox="1"/>
            <p:nvPr/>
          </p:nvSpPr>
          <p:spPr>
            <a:xfrm>
              <a:off x="5360917" y="583328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48786E06-8C33-42E6-99D4-BA6D28A7EFF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7201" y="346300"/>
              <a:ext cx="2773869" cy="2523383"/>
              <a:chOff x="1922780" y="1095457"/>
              <a:chExt cx="7550928" cy="5119074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B4683DD6-B97E-4B4F-98CB-DFA2DB4DC1BB}"/>
                  </a:ext>
                </a:extLst>
              </p:cNvPr>
              <p:cNvSpPr txBox="1"/>
              <p:nvPr/>
            </p:nvSpPr>
            <p:spPr>
              <a:xfrm>
                <a:off x="6565339" y="5303747"/>
                <a:ext cx="2908369" cy="4058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Symbol" pitchFamily="2" charset="2"/>
                    <a:cs typeface="Arial" panose="020B0604020202020204" pitchFamily="34" charset="0"/>
                  </a:rPr>
                  <a:t>b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</p:txBody>
          </p:sp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55917D52-C48D-4A7C-A8D6-9B720ECE75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447" t="14020" r="6189" b="61478"/>
              <a:stretch/>
            </p:blipFill>
            <p:spPr>
              <a:xfrm>
                <a:off x="5145184" y="3422838"/>
                <a:ext cx="1460420" cy="1052443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CB1890DB-2197-4C83-AB48-5A73A3882F25}"/>
                  </a:ext>
                </a:extLst>
              </p:cNvPr>
              <p:cNvSpPr txBox="1"/>
              <p:nvPr/>
            </p:nvSpPr>
            <p:spPr>
              <a:xfrm rot="18452861">
                <a:off x="3475929" y="2528112"/>
                <a:ext cx="1511990" cy="628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6531926-0764-42B8-A222-D8C0BCAF1C67}"/>
                  </a:ext>
                </a:extLst>
              </p:cNvPr>
              <p:cNvSpPr txBox="1"/>
              <p:nvPr/>
            </p:nvSpPr>
            <p:spPr>
              <a:xfrm rot="18452861">
                <a:off x="3815080" y="2172929"/>
                <a:ext cx="2553768" cy="628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.1 µM ruxolitinib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5FECF7A-0722-4063-8ED6-7F9715B53C80}"/>
                  </a:ext>
                </a:extLst>
              </p:cNvPr>
              <p:cNvSpPr txBox="1"/>
              <p:nvPr/>
            </p:nvSpPr>
            <p:spPr>
              <a:xfrm rot="18452861">
                <a:off x="5917115" y="2275632"/>
                <a:ext cx="2148906" cy="628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.5 µM ruxolitinib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985D748-AF90-401B-B960-659536A57948}"/>
                  </a:ext>
                </a:extLst>
              </p:cNvPr>
              <p:cNvSpPr txBox="1"/>
              <p:nvPr/>
            </p:nvSpPr>
            <p:spPr>
              <a:xfrm rot="18452861">
                <a:off x="5029446" y="2528362"/>
                <a:ext cx="1583269" cy="628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2D610574-BD93-4DB8-8C06-9A1855355F6A}"/>
                  </a:ext>
                </a:extLst>
              </p:cNvPr>
              <p:cNvSpPr txBox="1"/>
              <p:nvPr/>
            </p:nvSpPr>
            <p:spPr>
              <a:xfrm rot="18452861">
                <a:off x="5385734" y="2089939"/>
                <a:ext cx="2617328" cy="628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.1 µM ruxolitinib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A23ED6A4-ED44-4957-8C3C-52A0EC12A283}"/>
                  </a:ext>
                </a:extLst>
              </p:cNvPr>
              <p:cNvSpPr txBox="1"/>
              <p:nvPr/>
            </p:nvSpPr>
            <p:spPr>
              <a:xfrm rot="18452861">
                <a:off x="4347479" y="2308965"/>
                <a:ext cx="2145979" cy="628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.5 µM ruxolitinib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BCEB4587-F32F-4BC3-8CBF-AFD38553715A}"/>
                  </a:ext>
                </a:extLst>
              </p:cNvPr>
              <p:cNvSpPr txBox="1"/>
              <p:nvPr/>
            </p:nvSpPr>
            <p:spPr>
              <a:xfrm>
                <a:off x="6565339" y="3646901"/>
                <a:ext cx="2349547" cy="624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STAT5 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(Y694)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DD7F163-B734-4160-9566-099727C1836C}"/>
                  </a:ext>
                </a:extLst>
              </p:cNvPr>
              <p:cNvSpPr txBox="1"/>
              <p:nvPr/>
            </p:nvSpPr>
            <p:spPr>
              <a:xfrm>
                <a:off x="6565339" y="4519272"/>
                <a:ext cx="2908369" cy="624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ERK1/2 </a:t>
                </a:r>
              </a:p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(T202/Y204)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66AE001-1AA0-4495-9EA8-476A8AEC1049}"/>
                  </a:ext>
                </a:extLst>
              </p:cNvPr>
              <p:cNvSpPr txBox="1"/>
              <p:nvPr/>
            </p:nvSpPr>
            <p:spPr>
              <a:xfrm>
                <a:off x="3431194" y="5746252"/>
                <a:ext cx="1842979" cy="4682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D517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AA868AB-9C9C-4013-93F1-2F8BE332F449}"/>
                  </a:ext>
                </a:extLst>
              </p:cNvPr>
              <p:cNvSpPr txBox="1"/>
              <p:nvPr/>
            </p:nvSpPr>
            <p:spPr>
              <a:xfrm>
                <a:off x="4954694" y="5746252"/>
                <a:ext cx="1842979" cy="4682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D528</a:t>
                </a:r>
              </a:p>
            </p:txBody>
          </p:sp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B686701D-77B0-4804-9A44-AC16AB095D7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413" t="14321" r="28144" b="61266"/>
              <a:stretch/>
            </p:blipFill>
            <p:spPr>
              <a:xfrm>
                <a:off x="3622475" y="3422838"/>
                <a:ext cx="1455653" cy="1052443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B7239C6-8D57-439E-9180-D1B52E7E36AD}"/>
                  </a:ext>
                </a:extLst>
              </p:cNvPr>
              <p:cNvSpPr txBox="1"/>
              <p:nvPr/>
            </p:nvSpPr>
            <p:spPr>
              <a:xfrm>
                <a:off x="1922780" y="5746252"/>
                <a:ext cx="1842979" cy="4682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ND410</a:t>
                </a:r>
              </a:p>
            </p:txBody>
          </p:sp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4ED60477-1303-4D3D-B5F7-CEA3247ADD1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849" t="11774" r="76708" b="63896"/>
              <a:stretch/>
            </p:blipFill>
            <p:spPr>
              <a:xfrm>
                <a:off x="2122629" y="3422838"/>
                <a:ext cx="1449806" cy="1052443"/>
              </a:xfrm>
              <a:prstGeom prst="rect">
                <a:avLst/>
              </a:prstGeom>
            </p:spPr>
          </p:pic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908C3E7C-2124-4EC3-B53D-84E8E2E9DFA7}"/>
                  </a:ext>
                </a:extLst>
              </p:cNvPr>
              <p:cNvSpPr txBox="1"/>
              <p:nvPr/>
            </p:nvSpPr>
            <p:spPr>
              <a:xfrm rot="18452861">
                <a:off x="1969585" y="2526366"/>
                <a:ext cx="1516390" cy="628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B07E14A5-F360-48BD-9A03-7E2D04A7C006}"/>
                  </a:ext>
                </a:extLst>
              </p:cNvPr>
              <p:cNvSpPr txBox="1"/>
              <p:nvPr/>
            </p:nvSpPr>
            <p:spPr>
              <a:xfrm rot="18452861">
                <a:off x="2304250" y="2155862"/>
                <a:ext cx="2451021" cy="628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.1 µM ruxolitinib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DF95B668-9F30-46B1-A9CA-A07B18311E6C}"/>
                  </a:ext>
                </a:extLst>
              </p:cNvPr>
              <p:cNvSpPr txBox="1"/>
              <p:nvPr/>
            </p:nvSpPr>
            <p:spPr>
              <a:xfrm rot="18452861">
                <a:off x="2782847" y="2145388"/>
                <a:ext cx="2477453" cy="6283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.5 µM ruxolitinib</a:t>
                </a:r>
              </a:p>
            </p:txBody>
          </p:sp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AE2A608F-D114-4E7D-B34B-048827E6438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15" t="54810" r="82135" b="38981"/>
              <a:stretch/>
            </p:blipFill>
            <p:spPr>
              <a:xfrm>
                <a:off x="2107386" y="5278570"/>
                <a:ext cx="1460422" cy="463627"/>
              </a:xfrm>
              <a:prstGeom prst="rect">
                <a:avLst/>
              </a:prstGeom>
            </p:spPr>
          </p:pic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90717BE7-06F9-4506-A7D1-8899CF5B57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226" t="55300" r="60924" b="38491"/>
              <a:stretch/>
            </p:blipFill>
            <p:spPr>
              <a:xfrm>
                <a:off x="3629457" y="5274515"/>
                <a:ext cx="1460422" cy="463627"/>
              </a:xfrm>
              <a:prstGeom prst="rect">
                <a:avLst/>
              </a:prstGeom>
            </p:spPr>
          </p:pic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30BD5204-4A21-4CA2-B560-CF25E7B9EB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609" t="55300" r="36541" b="38491"/>
              <a:stretch/>
            </p:blipFill>
            <p:spPr>
              <a:xfrm>
                <a:off x="5145180" y="5281816"/>
                <a:ext cx="1460422" cy="463627"/>
              </a:xfrm>
              <a:prstGeom prst="rect">
                <a:avLst/>
              </a:prstGeom>
            </p:spPr>
          </p:pic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E2474B5D-FFDF-4767-A707-B07D99AD3B2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447" t="53179" r="6189" b="33048"/>
              <a:stretch/>
            </p:blipFill>
            <p:spPr>
              <a:xfrm>
                <a:off x="5125422" y="4592862"/>
                <a:ext cx="1478695" cy="591589"/>
              </a:xfrm>
              <a:prstGeom prst="rect">
                <a:avLst/>
              </a:prstGeom>
            </p:spPr>
          </p:pic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310A40AC-9E29-4BA7-B0F1-B2BE02492F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413" t="53338" r="28144" b="32939"/>
              <a:stretch/>
            </p:blipFill>
            <p:spPr>
              <a:xfrm>
                <a:off x="3602714" y="4592862"/>
                <a:ext cx="1455653" cy="591589"/>
              </a:xfrm>
              <a:prstGeom prst="rect">
                <a:avLst/>
              </a:prstGeom>
            </p:spPr>
          </p:pic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EC7CC694-0AA2-460D-AA73-576E12EAC0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849" t="50658" r="76708" b="35666"/>
              <a:stretch/>
            </p:blipFill>
            <p:spPr>
              <a:xfrm>
                <a:off x="2102868" y="4592862"/>
                <a:ext cx="1449806" cy="591589"/>
              </a:xfrm>
              <a:prstGeom prst="rect">
                <a:avLst/>
              </a:prstGeom>
            </p:spPr>
          </p:pic>
        </p:grp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89AE8D6E-0D8C-4C48-B96D-BBD796573484}"/>
                </a:ext>
              </a:extLst>
            </p:cNvPr>
            <p:cNvSpPr txBox="1"/>
            <p:nvPr/>
          </p:nvSpPr>
          <p:spPr>
            <a:xfrm>
              <a:off x="2531703" y="583328"/>
              <a:ext cx="3818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60" name="Object 59">
              <a:extLst>
                <a:ext uri="{FF2B5EF4-FFF2-40B4-BE49-F238E27FC236}">
                  <a16:creationId xmlns:a16="http://schemas.microsoft.com/office/drawing/2014/main" id="{53ACFE4B-B434-47C4-A001-EF08AC914B0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2227968"/>
                </p:ext>
              </p:extLst>
            </p:nvPr>
          </p:nvGraphicFramePr>
          <p:xfrm>
            <a:off x="4469812" y="5315606"/>
            <a:ext cx="2338388" cy="17986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1" imgW="4646831" imgH="3549318" progId="Prism9.Document">
                    <p:embed/>
                  </p:oleObj>
                </mc:Choice>
                <mc:Fallback>
                  <p:oleObj name="Prism 9" r:id="rId11" imgW="4646831" imgH="3549318" progId="Prism9.Document">
                    <p:embed/>
                    <p:pic>
                      <p:nvPicPr>
                        <p:cNvPr id="60" name="Object 59">
                          <a:extLst>
                            <a:ext uri="{FF2B5EF4-FFF2-40B4-BE49-F238E27FC236}">
                              <a16:creationId xmlns:a16="http://schemas.microsoft.com/office/drawing/2014/main" id="{53ACFE4B-B434-47C4-A001-EF08AC914B0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469812" y="5315606"/>
                          <a:ext cx="2338388" cy="17986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1" name="Object 60">
              <a:extLst>
                <a:ext uri="{FF2B5EF4-FFF2-40B4-BE49-F238E27FC236}">
                  <a16:creationId xmlns:a16="http://schemas.microsoft.com/office/drawing/2014/main" id="{270305F2-1D45-4235-A159-FB2C3B9C56E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67517037"/>
                </p:ext>
              </p:extLst>
            </p:nvPr>
          </p:nvGraphicFramePr>
          <p:xfrm>
            <a:off x="2233945" y="5292728"/>
            <a:ext cx="2454275" cy="1824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3" imgW="4893884" imgH="3530950" progId="Prism9.Document">
                    <p:embed/>
                  </p:oleObj>
                </mc:Choice>
                <mc:Fallback>
                  <p:oleObj name="Prism 9" r:id="rId13" imgW="4893884" imgH="3530950" progId="Prism9.Document">
                    <p:embed/>
                    <p:pic>
                      <p:nvPicPr>
                        <p:cNvPr id="61" name="Object 60">
                          <a:extLst>
                            <a:ext uri="{FF2B5EF4-FFF2-40B4-BE49-F238E27FC236}">
                              <a16:creationId xmlns:a16="http://schemas.microsoft.com/office/drawing/2014/main" id="{270305F2-1D45-4235-A159-FB2C3B9C56E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233945" y="5292728"/>
                          <a:ext cx="2454275" cy="18240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9" name="Object 48">
              <a:extLst>
                <a:ext uri="{FF2B5EF4-FFF2-40B4-BE49-F238E27FC236}">
                  <a16:creationId xmlns:a16="http://schemas.microsoft.com/office/drawing/2014/main" id="{E5C20282-97DF-4116-B830-CEE2F5EB5A0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67326253"/>
                </p:ext>
              </p:extLst>
            </p:nvPr>
          </p:nvGraphicFramePr>
          <p:xfrm>
            <a:off x="4378632" y="3019636"/>
            <a:ext cx="2442883" cy="179222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4736865" imgH="3485211" progId="Prism9.Document">
                    <p:embed/>
                  </p:oleObj>
                </mc:Choice>
                <mc:Fallback>
                  <p:oleObj name="Prism 9" r:id="rId15" imgW="4736865" imgH="3485211" progId="Prism9.Document">
                    <p:embed/>
                    <p:pic>
                      <p:nvPicPr>
                        <p:cNvPr id="49" name="Object 48">
                          <a:extLst>
                            <a:ext uri="{FF2B5EF4-FFF2-40B4-BE49-F238E27FC236}">
                              <a16:creationId xmlns:a16="http://schemas.microsoft.com/office/drawing/2014/main" id="{E5C20282-97DF-4116-B830-CEE2F5EB5A0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4378632" y="3019636"/>
                          <a:ext cx="2442883" cy="179222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0" name="Object 49">
              <a:extLst>
                <a:ext uri="{FF2B5EF4-FFF2-40B4-BE49-F238E27FC236}">
                  <a16:creationId xmlns:a16="http://schemas.microsoft.com/office/drawing/2014/main" id="{E08C7020-F411-4C51-98A8-0071A79C7F7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644492"/>
                </p:ext>
              </p:extLst>
            </p:nvPr>
          </p:nvGraphicFramePr>
          <p:xfrm>
            <a:off x="2278587" y="3086155"/>
            <a:ext cx="2343202" cy="173736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7" imgW="4427508" imgH="3284245" progId="Prism9.Document">
                    <p:embed/>
                  </p:oleObj>
                </mc:Choice>
                <mc:Fallback>
                  <p:oleObj name="Prism 9" r:id="rId17" imgW="4427508" imgH="3284245" progId="Prism9.Document">
                    <p:embed/>
                    <p:pic>
                      <p:nvPicPr>
                        <p:cNvPr id="50" name="Object 49">
                          <a:extLst>
                            <a:ext uri="{FF2B5EF4-FFF2-40B4-BE49-F238E27FC236}">
                              <a16:creationId xmlns:a16="http://schemas.microsoft.com/office/drawing/2014/main" id="{E08C7020-F411-4C51-98A8-0071A79C7F7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2278587" y="3086155"/>
                          <a:ext cx="2343202" cy="173736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3" name="Object 52">
              <a:extLst>
                <a:ext uri="{FF2B5EF4-FFF2-40B4-BE49-F238E27FC236}">
                  <a16:creationId xmlns:a16="http://schemas.microsoft.com/office/drawing/2014/main" id="{B2192034-FD77-4C56-A190-3DB661DEA56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71120652"/>
                </p:ext>
              </p:extLst>
            </p:nvPr>
          </p:nvGraphicFramePr>
          <p:xfrm>
            <a:off x="268288" y="3050127"/>
            <a:ext cx="2105025" cy="1906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9" imgW="4121033" imgH="3732276" progId="Prism9.Document">
                    <p:embed/>
                  </p:oleObj>
                </mc:Choice>
                <mc:Fallback>
                  <p:oleObj name="Prism 9" r:id="rId19" imgW="4121033" imgH="3732276" progId="Prism9.Document">
                    <p:embed/>
                    <p:pic>
                      <p:nvPicPr>
                        <p:cNvPr id="53" name="Object 52">
                          <a:extLst>
                            <a:ext uri="{FF2B5EF4-FFF2-40B4-BE49-F238E27FC236}">
                              <a16:creationId xmlns:a16="http://schemas.microsoft.com/office/drawing/2014/main" id="{B2192034-FD77-4C56-A190-3DB661DEA56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268288" y="3050127"/>
                          <a:ext cx="2105025" cy="1906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DFA639FD-C97F-F637-6446-2A5B29FABB3E}"/>
                </a:ext>
              </a:extLst>
            </p:cNvPr>
            <p:cNvSpPr txBox="1"/>
            <p:nvPr/>
          </p:nvSpPr>
          <p:spPr>
            <a:xfrm>
              <a:off x="4127090" y="583328"/>
              <a:ext cx="3818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65F8491D-E90E-6803-202B-B8B884693418}"/>
                </a:ext>
              </a:extLst>
            </p:cNvPr>
            <p:cNvGrpSpPr/>
            <p:nvPr/>
          </p:nvGrpSpPr>
          <p:grpSpPr>
            <a:xfrm>
              <a:off x="2581943" y="816171"/>
              <a:ext cx="4088263" cy="2258389"/>
              <a:chOff x="2581943" y="816171"/>
              <a:chExt cx="4088263" cy="2258389"/>
            </a:xfrm>
          </p:grpSpPr>
          <p:graphicFrame>
            <p:nvGraphicFramePr>
              <p:cNvPr id="7" name="Object 6">
                <a:extLst>
                  <a:ext uri="{FF2B5EF4-FFF2-40B4-BE49-F238E27FC236}">
                    <a16:creationId xmlns:a16="http://schemas.microsoft.com/office/drawing/2014/main" id="{585F4ED5-BF0C-2BEC-7AB8-1D2CD77E81D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04461569"/>
                  </p:ext>
                </p:extLst>
              </p:nvPr>
            </p:nvGraphicFramePr>
            <p:xfrm>
              <a:off x="2581943" y="1118760"/>
              <a:ext cx="2022551" cy="1955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21" imgW="2886128" imgH="2791554" progId="Prism9.Document">
                      <p:embed/>
                    </p:oleObj>
                  </mc:Choice>
                  <mc:Fallback>
                    <p:oleObj name="Prism 9" r:id="rId21" imgW="2886128" imgH="2791554" progId="Prism9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22"/>
                          <a:stretch>
                            <a:fillRect/>
                          </a:stretch>
                        </p:blipFill>
                        <p:spPr>
                          <a:xfrm>
                            <a:off x="2581943" y="1118760"/>
                            <a:ext cx="2022551" cy="19558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E062606F-FE09-33BC-B5CF-5926EE979BFA}"/>
                  </a:ext>
                </a:extLst>
              </p:cNvPr>
              <p:cNvSpPr/>
              <p:nvPr/>
            </p:nvSpPr>
            <p:spPr>
              <a:xfrm>
                <a:off x="3991351" y="1078293"/>
                <a:ext cx="610667" cy="914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aphicFrame>
            <p:nvGraphicFramePr>
              <p:cNvPr id="13" name="Object 12">
                <a:extLst>
                  <a:ext uri="{FF2B5EF4-FFF2-40B4-BE49-F238E27FC236}">
                    <a16:creationId xmlns:a16="http://schemas.microsoft.com/office/drawing/2014/main" id="{EE917ADE-3A0C-9514-BC11-FDA179A2615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98019178"/>
                  </p:ext>
                </p:extLst>
              </p:nvPr>
            </p:nvGraphicFramePr>
            <p:xfrm>
              <a:off x="3990502" y="816171"/>
              <a:ext cx="2095048" cy="216519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23" imgW="2934746" imgH="3033938" progId="Prism9.Document">
                      <p:embed/>
                    </p:oleObj>
                  </mc:Choice>
                  <mc:Fallback>
                    <p:oleObj name="Prism 9" r:id="rId23" imgW="2934746" imgH="3033938" progId="Prism9.Document">
                      <p:embed/>
                      <p:pic>
                        <p:nvPicPr>
                          <p:cNvPr id="11" name="Object 10">
                            <a:extLst>
                              <a:ext uri="{FF2B5EF4-FFF2-40B4-BE49-F238E27FC236}">
                                <a16:creationId xmlns:a16="http://schemas.microsoft.com/office/drawing/2014/main" id="{E05D7A68-DA72-F82D-3CAB-495687D6F1F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4"/>
                          <a:stretch>
                            <a:fillRect/>
                          </a:stretch>
                        </p:blipFill>
                        <p:spPr>
                          <a:xfrm>
                            <a:off x="3990502" y="816171"/>
                            <a:ext cx="2095048" cy="216519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A8F878FE-1891-6CB8-0A8A-7B068D045BBD}"/>
                  </a:ext>
                </a:extLst>
              </p:cNvPr>
              <p:cNvSpPr/>
              <p:nvPr/>
            </p:nvSpPr>
            <p:spPr>
              <a:xfrm>
                <a:off x="5258661" y="1136637"/>
                <a:ext cx="833799" cy="69110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F6A375D0-B297-E877-49D7-AD3F02C265FD}"/>
                  </a:ext>
                </a:extLst>
              </p:cNvPr>
              <p:cNvSpPr/>
              <p:nvPr/>
            </p:nvSpPr>
            <p:spPr>
              <a:xfrm>
                <a:off x="5270651" y="1393635"/>
                <a:ext cx="126622" cy="8071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EFA72AD8-CCD4-9974-E58C-14FC1508F394}"/>
                  </a:ext>
                </a:extLst>
              </p:cNvPr>
              <p:cNvSpPr/>
              <p:nvPr/>
            </p:nvSpPr>
            <p:spPr>
              <a:xfrm>
                <a:off x="4069166" y="1487124"/>
                <a:ext cx="126622" cy="8071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E5351A7F-055F-789C-9137-BFCBB4F3F77C}"/>
                  </a:ext>
                </a:extLst>
              </p:cNvPr>
              <p:cNvSpPr/>
              <p:nvPr/>
            </p:nvSpPr>
            <p:spPr>
              <a:xfrm>
                <a:off x="4608929" y="854998"/>
                <a:ext cx="610667" cy="2998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dirty="0"/>
                  <a:t>CCD4+D4+</a:t>
                </a:r>
              </a:p>
            </p:txBody>
          </p:sp>
          <p:cxnSp>
            <p:nvCxnSpPr>
              <p:cNvPr id="51" name="Straight Arrow Connector 50">
                <a:extLst>
                  <a:ext uri="{FF2B5EF4-FFF2-40B4-BE49-F238E27FC236}">
                    <a16:creationId xmlns:a16="http://schemas.microsoft.com/office/drawing/2014/main" id="{C8381449-2BB6-CF08-E87A-ACF34F10B9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74770" y="1925470"/>
                <a:ext cx="32004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57849C69-5548-2E5D-A3B4-B4B9E76D78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5252447" y="866948"/>
                <a:ext cx="1417759" cy="2103120"/>
              </a:xfrm>
              <a:prstGeom prst="rect">
                <a:avLst/>
              </a:prstGeom>
            </p:spPr>
          </p:pic>
          <p:sp>
            <p:nvSpPr>
              <p:cNvPr id="64" name="Rectangle 63">
                <a:extLst>
                  <a:ext uri="{FF2B5EF4-FFF2-40B4-BE49-F238E27FC236}">
                    <a16:creationId xmlns:a16="http://schemas.microsoft.com/office/drawing/2014/main" id="{8E9FA6E4-EBF6-F137-4477-A431C5A20D73}"/>
                  </a:ext>
                </a:extLst>
              </p:cNvPr>
              <p:cNvSpPr/>
              <p:nvPr/>
            </p:nvSpPr>
            <p:spPr>
              <a:xfrm>
                <a:off x="5799747" y="908137"/>
                <a:ext cx="610667" cy="2998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DDBB7DD0-EBD2-7C80-8DFF-5BCD5C473A92}"/>
                  </a:ext>
                </a:extLst>
              </p:cNvPr>
              <p:cNvSpPr txBox="1"/>
              <p:nvPr/>
            </p:nvSpPr>
            <p:spPr>
              <a:xfrm>
                <a:off x="3149470" y="1983621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0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6802B1C1-0B5D-68BD-3ED0-2BDA0403E749}"/>
                  </a:ext>
                </a:extLst>
              </p:cNvPr>
              <p:cNvSpPr txBox="1"/>
              <p:nvPr/>
            </p:nvSpPr>
            <p:spPr>
              <a:xfrm>
                <a:off x="3183934" y="1496933"/>
                <a:ext cx="2535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B50024E7-4D9F-0BED-3DC0-AA54DFF15878}"/>
                  </a:ext>
                </a:extLst>
              </p:cNvPr>
              <p:cNvSpPr txBox="1"/>
              <p:nvPr/>
            </p:nvSpPr>
            <p:spPr>
              <a:xfrm>
                <a:off x="3016174" y="1174729"/>
                <a:ext cx="5891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2/M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9AAF1396-5A12-2C2A-1FDA-6F733C3E6F06}"/>
                  </a:ext>
                </a:extLst>
              </p:cNvPr>
              <p:cNvSpPr txBox="1"/>
              <p:nvPr/>
            </p:nvSpPr>
            <p:spPr>
              <a:xfrm>
                <a:off x="4679191" y="860955"/>
                <a:ext cx="48282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4+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9B92DDED-03C3-55E7-906F-0A8B4C3DF986}"/>
                  </a:ext>
                </a:extLst>
              </p:cNvPr>
              <p:cNvSpPr txBox="1"/>
              <p:nvPr/>
            </p:nvSpPr>
            <p:spPr>
              <a:xfrm>
                <a:off x="5925760" y="860955"/>
                <a:ext cx="48282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8+</a:t>
                </a:r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73FC938E-62E2-D753-D54A-40EB9935EA97}"/>
                  </a:ext>
                </a:extLst>
              </p:cNvPr>
              <p:cNvSpPr/>
              <p:nvPr/>
            </p:nvSpPr>
            <p:spPr>
              <a:xfrm>
                <a:off x="5351035" y="1601669"/>
                <a:ext cx="126622" cy="6144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C692B626-DC38-8C20-3579-E83F99ADFD8E}"/>
                </a:ext>
              </a:extLst>
            </p:cNvPr>
            <p:cNvSpPr txBox="1"/>
            <p:nvPr/>
          </p:nvSpPr>
          <p:spPr>
            <a:xfrm rot="16200000">
              <a:off x="-319867" y="3648638"/>
              <a:ext cx="123623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liferation relative 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o vehicle at 24h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B969B34D-3DC2-15EE-21BF-515F678DC60E}"/>
                </a:ext>
              </a:extLst>
            </p:cNvPr>
            <p:cNvSpPr txBox="1"/>
            <p:nvPr/>
          </p:nvSpPr>
          <p:spPr>
            <a:xfrm>
              <a:off x="-19368" y="2948720"/>
              <a:ext cx="3818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EFB1D9D-6179-C721-7B48-8842E909A3C5}"/>
                </a:ext>
              </a:extLst>
            </p:cNvPr>
            <p:cNvSpPr txBox="1"/>
            <p:nvPr/>
          </p:nvSpPr>
          <p:spPr>
            <a:xfrm rot="16200000">
              <a:off x="1997004" y="3800456"/>
              <a:ext cx="813043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L-2 (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BD69F6A8-DBAA-5283-47AC-5B83031CB221}"/>
                </a:ext>
              </a:extLst>
            </p:cNvPr>
            <p:cNvSpPr txBox="1"/>
            <p:nvPr/>
          </p:nvSpPr>
          <p:spPr>
            <a:xfrm rot="16200000">
              <a:off x="4074509" y="3825822"/>
              <a:ext cx="902812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sz="900" dirty="0">
                  <a:latin typeface="Symbol" pitchFamily="2" charset="2"/>
                  <a:cs typeface="Arial" panose="020B0604020202020204" pitchFamily="34" charset="0"/>
                </a:rPr>
                <a:t>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17D565D3-EBC4-DA82-8161-B1EDA016D90B}"/>
                </a:ext>
              </a:extLst>
            </p:cNvPr>
            <p:cNvSpPr/>
            <p:nvPr/>
          </p:nvSpPr>
          <p:spPr>
            <a:xfrm>
              <a:off x="871894" y="3060558"/>
              <a:ext cx="965235" cy="2465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05360F3D-526B-BFBE-78AB-476000B48CFE}"/>
                </a:ext>
              </a:extLst>
            </p:cNvPr>
            <p:cNvSpPr/>
            <p:nvPr/>
          </p:nvSpPr>
          <p:spPr>
            <a:xfrm>
              <a:off x="3105651" y="3153127"/>
              <a:ext cx="965235" cy="2465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042AEE62-A280-0C95-79B9-C28B8ADFE52D}"/>
                </a:ext>
              </a:extLst>
            </p:cNvPr>
            <p:cNvSpPr/>
            <p:nvPr/>
          </p:nvSpPr>
          <p:spPr>
            <a:xfrm>
              <a:off x="5283336" y="3052831"/>
              <a:ext cx="965235" cy="2465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DAD4F024-07EB-7DB1-6620-74879D24969E}"/>
                </a:ext>
              </a:extLst>
            </p:cNvPr>
            <p:cNvSpPr/>
            <p:nvPr/>
          </p:nvSpPr>
          <p:spPr>
            <a:xfrm>
              <a:off x="2967395" y="4427715"/>
              <a:ext cx="1346724" cy="32206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0464BC1E-74B6-2B79-C284-377C625E04CA}"/>
                </a:ext>
              </a:extLst>
            </p:cNvPr>
            <p:cNvSpPr/>
            <p:nvPr/>
          </p:nvSpPr>
          <p:spPr>
            <a:xfrm>
              <a:off x="5098140" y="4437764"/>
              <a:ext cx="1346724" cy="32206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AE485B44-95B4-8B34-9F15-9A12F73126CF}"/>
                </a:ext>
              </a:extLst>
            </p:cNvPr>
            <p:cNvSpPr txBox="1"/>
            <p:nvPr/>
          </p:nvSpPr>
          <p:spPr>
            <a:xfrm>
              <a:off x="2908609" y="4419735"/>
              <a:ext cx="14029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4    48    72    96    120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60008537-E45E-10A8-F7CC-65D001C1624A}"/>
                </a:ext>
              </a:extLst>
            </p:cNvPr>
            <p:cNvSpPr txBox="1"/>
            <p:nvPr/>
          </p:nvSpPr>
          <p:spPr>
            <a:xfrm>
              <a:off x="5058650" y="4419735"/>
              <a:ext cx="14029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4    48    72    96    120</a:t>
              </a:r>
            </a:p>
          </p:txBody>
        </p:sp>
        <p:graphicFrame>
          <p:nvGraphicFramePr>
            <p:cNvPr id="88" name="Object 87">
              <a:extLst>
                <a:ext uri="{FF2B5EF4-FFF2-40B4-BE49-F238E27FC236}">
                  <a16:creationId xmlns:a16="http://schemas.microsoft.com/office/drawing/2014/main" id="{E1D9741A-6736-6D8F-BA33-27A202FC7D4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90066717"/>
                </p:ext>
              </p:extLst>
            </p:nvPr>
          </p:nvGraphicFramePr>
          <p:xfrm>
            <a:off x="230878" y="5262802"/>
            <a:ext cx="2201380" cy="1853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6" imgW="4175774" imgH="3503579" progId="Prism9.Document">
                    <p:embed/>
                  </p:oleObj>
                </mc:Choice>
                <mc:Fallback>
                  <p:oleObj name="Prism 9" r:id="rId26" imgW="4175774" imgH="3503579" progId="Prism9.Document">
                    <p:embed/>
                    <p:pic>
                      <p:nvPicPr>
                        <p:cNvPr id="59" name="Object 58">
                          <a:extLst>
                            <a:ext uri="{FF2B5EF4-FFF2-40B4-BE49-F238E27FC236}">
                              <a16:creationId xmlns:a16="http://schemas.microsoft.com/office/drawing/2014/main" id="{184D6A68-EB61-4978-8F80-D6B41B1B97D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230878" y="5262802"/>
                          <a:ext cx="2201380" cy="1853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A3B8B691-6446-3CA4-6155-E04D1F565EC5}"/>
                </a:ext>
              </a:extLst>
            </p:cNvPr>
            <p:cNvGrpSpPr/>
            <p:nvPr/>
          </p:nvGrpSpPr>
          <p:grpSpPr>
            <a:xfrm>
              <a:off x="697441" y="4439136"/>
              <a:ext cx="1346724" cy="396575"/>
              <a:chOff x="697441" y="4499424"/>
              <a:chExt cx="1346724" cy="396575"/>
            </a:xfrm>
          </p:grpSpPr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4F2F4D24-55F9-D6AE-7792-617E8C7ED57A}"/>
                  </a:ext>
                </a:extLst>
              </p:cNvPr>
              <p:cNvSpPr/>
              <p:nvPr/>
            </p:nvSpPr>
            <p:spPr>
              <a:xfrm>
                <a:off x="697441" y="4499424"/>
                <a:ext cx="1346724" cy="32206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D5DC7E3E-8861-6BEA-3BBE-F33D6A98DDDE}"/>
                  </a:ext>
                </a:extLst>
              </p:cNvPr>
              <p:cNvSpPr txBox="1"/>
              <p:nvPr/>
            </p:nvSpPr>
            <p:spPr>
              <a:xfrm>
                <a:off x="1083088" y="4665167"/>
                <a:ext cx="47320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</a:p>
            </p:txBody>
          </p:sp>
        </p:grp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48FED6BE-F87E-13E9-75AF-6DAA8E89474D}"/>
                </a:ext>
              </a:extLst>
            </p:cNvPr>
            <p:cNvSpPr txBox="1"/>
            <p:nvPr/>
          </p:nvSpPr>
          <p:spPr>
            <a:xfrm>
              <a:off x="3356273" y="4604879"/>
              <a:ext cx="4732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02224BE-78E7-71F3-DDC9-7CB4DA9B35CC}"/>
                </a:ext>
              </a:extLst>
            </p:cNvPr>
            <p:cNvSpPr txBox="1"/>
            <p:nvPr/>
          </p:nvSpPr>
          <p:spPr>
            <a:xfrm>
              <a:off x="5518264" y="4604879"/>
              <a:ext cx="4732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ours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457426B4-3A79-D30E-6D45-8EBB5749F2AC}"/>
                </a:ext>
              </a:extLst>
            </p:cNvPr>
            <p:cNvSpPr txBox="1"/>
            <p:nvPr/>
          </p:nvSpPr>
          <p:spPr>
            <a:xfrm rot="16200000">
              <a:off x="-369778" y="5990319"/>
              <a:ext cx="133674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liferation relative 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o vehicle at 24h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E48040E1-ED74-C58D-2B06-D0C92E297222}"/>
                </a:ext>
              </a:extLst>
            </p:cNvPr>
            <p:cNvSpPr txBox="1"/>
            <p:nvPr/>
          </p:nvSpPr>
          <p:spPr>
            <a:xfrm>
              <a:off x="-19368" y="5272697"/>
              <a:ext cx="3818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F60CEAB1-2DC0-AC7C-0E95-FFF25F1810CA}"/>
                </a:ext>
              </a:extLst>
            </p:cNvPr>
            <p:cNvGrpSpPr/>
            <p:nvPr/>
          </p:nvGrpSpPr>
          <p:grpSpPr>
            <a:xfrm>
              <a:off x="2886597" y="6715596"/>
              <a:ext cx="1531189" cy="415976"/>
              <a:chOff x="561786" y="4480023"/>
              <a:chExt cx="1531189" cy="415976"/>
            </a:xfrm>
          </p:grpSpPr>
          <p:sp>
            <p:nvSpPr>
              <p:cNvPr id="97" name="Rectangle 96">
                <a:extLst>
                  <a:ext uri="{FF2B5EF4-FFF2-40B4-BE49-F238E27FC236}">
                    <a16:creationId xmlns:a16="http://schemas.microsoft.com/office/drawing/2014/main" id="{732E750B-8936-B514-22A3-A2F585DF5C66}"/>
                  </a:ext>
                </a:extLst>
              </p:cNvPr>
              <p:cNvSpPr/>
              <p:nvPr/>
            </p:nvSpPr>
            <p:spPr>
              <a:xfrm>
                <a:off x="621241" y="4499424"/>
                <a:ext cx="1346724" cy="32206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4E27567F-BC2E-0EEC-F668-8CD6914C9AF2}"/>
                  </a:ext>
                </a:extLst>
              </p:cNvPr>
              <p:cNvSpPr txBox="1"/>
              <p:nvPr/>
            </p:nvSpPr>
            <p:spPr>
              <a:xfrm>
                <a:off x="1083088" y="4665167"/>
                <a:ext cx="47320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38F5BB1A-99A5-8B20-CBB6-0BC8267CB0C5}"/>
                  </a:ext>
                </a:extLst>
              </p:cNvPr>
              <p:cNvSpPr txBox="1"/>
              <p:nvPr/>
            </p:nvSpPr>
            <p:spPr>
              <a:xfrm>
                <a:off x="561786" y="4480023"/>
                <a:ext cx="153118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4     48     72      96    120</a:t>
                </a:r>
              </a:p>
            </p:txBody>
          </p:sp>
        </p:grpSp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00370F80-B196-7AE1-BBA1-7AF9D56108BB}"/>
                </a:ext>
              </a:extLst>
            </p:cNvPr>
            <p:cNvGrpSpPr/>
            <p:nvPr/>
          </p:nvGrpSpPr>
          <p:grpSpPr>
            <a:xfrm>
              <a:off x="634423" y="6697176"/>
              <a:ext cx="1499128" cy="415976"/>
              <a:chOff x="577816" y="4480023"/>
              <a:chExt cx="1499128" cy="415976"/>
            </a:xfrm>
          </p:grpSpPr>
          <p:sp>
            <p:nvSpPr>
              <p:cNvPr id="102" name="Rectangle 101">
                <a:extLst>
                  <a:ext uri="{FF2B5EF4-FFF2-40B4-BE49-F238E27FC236}">
                    <a16:creationId xmlns:a16="http://schemas.microsoft.com/office/drawing/2014/main" id="{054B8EE1-4276-693E-6999-E9F658A947EC}"/>
                  </a:ext>
                </a:extLst>
              </p:cNvPr>
              <p:cNvSpPr/>
              <p:nvPr/>
            </p:nvSpPr>
            <p:spPr>
              <a:xfrm>
                <a:off x="621241" y="4499424"/>
                <a:ext cx="1346724" cy="32206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996511BF-1ECD-36F5-976C-41075C320547}"/>
                  </a:ext>
                </a:extLst>
              </p:cNvPr>
              <p:cNvSpPr txBox="1"/>
              <p:nvPr/>
            </p:nvSpPr>
            <p:spPr>
              <a:xfrm>
                <a:off x="1083088" y="4665167"/>
                <a:ext cx="47320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4AB791EE-42E8-1A32-16F6-40ACCC11F1AA}"/>
                  </a:ext>
                </a:extLst>
              </p:cNvPr>
              <p:cNvSpPr txBox="1"/>
              <p:nvPr/>
            </p:nvSpPr>
            <p:spPr>
              <a:xfrm>
                <a:off x="577816" y="4480023"/>
                <a:ext cx="149912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4     48     72     96    120</a:t>
                </a:r>
              </a:p>
            </p:txBody>
          </p:sp>
        </p:grpSp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3308B1E5-C475-857E-279C-8588F7552C48}"/>
                </a:ext>
              </a:extLst>
            </p:cNvPr>
            <p:cNvGrpSpPr/>
            <p:nvPr/>
          </p:nvGrpSpPr>
          <p:grpSpPr>
            <a:xfrm>
              <a:off x="5002950" y="6715596"/>
              <a:ext cx="1531189" cy="415976"/>
              <a:chOff x="561786" y="4480023"/>
              <a:chExt cx="1531189" cy="415976"/>
            </a:xfrm>
          </p:grpSpPr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id="{48D428F8-47F9-480E-D235-FFBA3AF116DF}"/>
                  </a:ext>
                </a:extLst>
              </p:cNvPr>
              <p:cNvSpPr/>
              <p:nvPr/>
            </p:nvSpPr>
            <p:spPr>
              <a:xfrm>
                <a:off x="621241" y="4499424"/>
                <a:ext cx="1346724" cy="32206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96AEDDA6-50D8-00DD-66C7-3193C4AAEAAE}"/>
                  </a:ext>
                </a:extLst>
              </p:cNvPr>
              <p:cNvSpPr txBox="1"/>
              <p:nvPr/>
            </p:nvSpPr>
            <p:spPr>
              <a:xfrm>
                <a:off x="1083088" y="4665167"/>
                <a:ext cx="47320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45C96998-3AD5-BD24-082C-4898D135A726}"/>
                  </a:ext>
                </a:extLst>
              </p:cNvPr>
              <p:cNvSpPr txBox="1"/>
              <p:nvPr/>
            </p:nvSpPr>
            <p:spPr>
              <a:xfrm>
                <a:off x="561786" y="4480023"/>
                <a:ext cx="153118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4     48     72      96    120</a:t>
                </a:r>
              </a:p>
            </p:txBody>
          </p:sp>
        </p:grp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D00D18F2-56B0-7236-3729-185074895EF9}"/>
                </a:ext>
              </a:extLst>
            </p:cNvPr>
            <p:cNvSpPr txBox="1"/>
            <p:nvPr/>
          </p:nvSpPr>
          <p:spPr>
            <a:xfrm rot="16200000">
              <a:off x="1930288" y="6079412"/>
              <a:ext cx="813043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L-2 (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0811B18F-F2A6-894F-161B-8D0AD12EC262}"/>
                </a:ext>
              </a:extLst>
            </p:cNvPr>
            <p:cNvSpPr txBox="1"/>
            <p:nvPr/>
          </p:nvSpPr>
          <p:spPr>
            <a:xfrm rot="16200000">
              <a:off x="4167593" y="6106877"/>
              <a:ext cx="902812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FN-</a:t>
              </a:r>
              <a:r>
                <a:rPr lang="en-US" sz="900" dirty="0">
                  <a:latin typeface="Symbol" pitchFamily="2" charset="2"/>
                  <a:cs typeface="Arial" panose="020B0604020202020204" pitchFamily="34" charset="0"/>
                </a:rPr>
                <a:t>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DA529165-A161-9446-933E-85B6A0DC23EC}"/>
                </a:ext>
              </a:extLst>
            </p:cNvPr>
            <p:cNvSpPr/>
            <p:nvPr/>
          </p:nvSpPr>
          <p:spPr>
            <a:xfrm>
              <a:off x="3189847" y="5373886"/>
              <a:ext cx="965235" cy="2465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E3BDD930-EAD6-EEB1-3CF1-D34FC0975537}"/>
                </a:ext>
              </a:extLst>
            </p:cNvPr>
            <p:cNvSpPr/>
            <p:nvPr/>
          </p:nvSpPr>
          <p:spPr>
            <a:xfrm>
              <a:off x="5309263" y="5325209"/>
              <a:ext cx="965235" cy="2465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529F0161-85BD-0A5B-3DCB-F399E1FD8C08}"/>
                </a:ext>
              </a:extLst>
            </p:cNvPr>
            <p:cNvSpPr/>
            <p:nvPr/>
          </p:nvSpPr>
          <p:spPr>
            <a:xfrm>
              <a:off x="1025217" y="5514886"/>
              <a:ext cx="965235" cy="2465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4B3A0677-7B36-0B9F-F901-288708B9DF3E}"/>
                </a:ext>
              </a:extLst>
            </p:cNvPr>
            <p:cNvSpPr/>
            <p:nvPr/>
          </p:nvSpPr>
          <p:spPr>
            <a:xfrm>
              <a:off x="881089" y="5341064"/>
              <a:ext cx="1143483" cy="2465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24" name="Group 123">
              <a:extLst>
                <a:ext uri="{FF2B5EF4-FFF2-40B4-BE49-F238E27FC236}">
                  <a16:creationId xmlns:a16="http://schemas.microsoft.com/office/drawing/2014/main" id="{5372CA77-ABF0-389A-0B85-EB0C4F227DB0}"/>
                </a:ext>
              </a:extLst>
            </p:cNvPr>
            <p:cNvGrpSpPr/>
            <p:nvPr/>
          </p:nvGrpSpPr>
          <p:grpSpPr>
            <a:xfrm>
              <a:off x="-29963" y="7169875"/>
              <a:ext cx="7003519" cy="316306"/>
              <a:chOff x="10229" y="7099537"/>
              <a:chExt cx="7003519" cy="316306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A7324B56-874E-F981-CEBB-75C21155DA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8"/>
              <a:srcRect t="90173"/>
              <a:stretch/>
            </p:blipFill>
            <p:spPr>
              <a:xfrm>
                <a:off x="10229" y="7099537"/>
                <a:ext cx="6858000" cy="316306"/>
              </a:xfrm>
              <a:prstGeom prst="rect">
                <a:avLst/>
              </a:prstGeom>
            </p:spPr>
          </p:pic>
          <p:sp>
            <p:nvSpPr>
              <p:cNvPr id="92" name="Rectangle 91">
                <a:extLst>
                  <a:ext uri="{FF2B5EF4-FFF2-40B4-BE49-F238E27FC236}">
                    <a16:creationId xmlns:a16="http://schemas.microsoft.com/office/drawing/2014/main" id="{81C17A30-126B-8775-31BD-521878E3455C}"/>
                  </a:ext>
                </a:extLst>
              </p:cNvPr>
              <p:cNvSpPr/>
              <p:nvPr/>
            </p:nvSpPr>
            <p:spPr>
              <a:xfrm>
                <a:off x="289081" y="7123679"/>
                <a:ext cx="462221" cy="22916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6" name="Rectangle 115">
                <a:extLst>
                  <a:ext uri="{FF2B5EF4-FFF2-40B4-BE49-F238E27FC236}">
                    <a16:creationId xmlns:a16="http://schemas.microsoft.com/office/drawing/2014/main" id="{9836B095-317F-E903-4A4D-DC5607DAE9AA}"/>
                  </a:ext>
                </a:extLst>
              </p:cNvPr>
              <p:cNvSpPr/>
              <p:nvPr/>
            </p:nvSpPr>
            <p:spPr>
              <a:xfrm>
                <a:off x="998679" y="7129807"/>
                <a:ext cx="768112" cy="22303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0" name="Rectangle 119">
                <a:extLst>
                  <a:ext uri="{FF2B5EF4-FFF2-40B4-BE49-F238E27FC236}">
                    <a16:creationId xmlns:a16="http://schemas.microsoft.com/office/drawing/2014/main" id="{3E0D2FE4-AB96-83C8-34C5-8739AD10878E}"/>
                  </a:ext>
                </a:extLst>
              </p:cNvPr>
              <p:cNvSpPr/>
              <p:nvPr/>
            </p:nvSpPr>
            <p:spPr>
              <a:xfrm>
                <a:off x="2003126" y="7152742"/>
                <a:ext cx="682320" cy="2001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9C0DD981-9AE1-3C0D-2874-B7B49177C37C}"/>
                  </a:ext>
                </a:extLst>
              </p:cNvPr>
              <p:cNvSpPr/>
              <p:nvPr/>
            </p:nvSpPr>
            <p:spPr>
              <a:xfrm>
                <a:off x="2919806" y="7152742"/>
                <a:ext cx="1388488" cy="16049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id="{DF6185E6-1F9D-4E79-2E71-2C441097A678}"/>
                  </a:ext>
                </a:extLst>
              </p:cNvPr>
              <p:cNvSpPr/>
              <p:nvPr/>
            </p:nvSpPr>
            <p:spPr>
              <a:xfrm>
                <a:off x="4551451" y="7161604"/>
                <a:ext cx="682320" cy="2001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id="{7DB42E5D-E770-1EBF-9914-95753F2CC28B}"/>
                  </a:ext>
                </a:extLst>
              </p:cNvPr>
              <p:cNvSpPr/>
              <p:nvPr/>
            </p:nvSpPr>
            <p:spPr>
              <a:xfrm>
                <a:off x="5421401" y="7176190"/>
                <a:ext cx="1388488" cy="16049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E6BB6698-6463-7277-443A-EAA7DD2B18A2}"/>
                  </a:ext>
                </a:extLst>
              </p:cNvPr>
              <p:cNvSpPr txBox="1"/>
              <p:nvPr/>
            </p:nvSpPr>
            <p:spPr>
              <a:xfrm>
                <a:off x="246563" y="7122014"/>
                <a:ext cx="676718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          TSLPRCART           0.1 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0.1 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+ TSLPRCART         0.5 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0.5 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+ TSLPRCART </a:t>
                </a:r>
              </a:p>
            </p:txBody>
          </p:sp>
        </p:grpSp>
        <p:grpSp>
          <p:nvGrpSpPr>
            <p:cNvPr id="125" name="Group 124">
              <a:extLst>
                <a:ext uri="{FF2B5EF4-FFF2-40B4-BE49-F238E27FC236}">
                  <a16:creationId xmlns:a16="http://schemas.microsoft.com/office/drawing/2014/main" id="{8F13EE28-DAB9-C0EE-9BDE-5F458380545E}"/>
                </a:ext>
              </a:extLst>
            </p:cNvPr>
            <p:cNvGrpSpPr/>
            <p:nvPr/>
          </p:nvGrpSpPr>
          <p:grpSpPr>
            <a:xfrm>
              <a:off x="-29963" y="4859737"/>
              <a:ext cx="7003519" cy="316306"/>
              <a:chOff x="10229" y="7099537"/>
              <a:chExt cx="7003519" cy="316306"/>
            </a:xfrm>
          </p:grpSpPr>
          <p:pic>
            <p:nvPicPr>
              <p:cNvPr id="126" name="Picture 125">
                <a:extLst>
                  <a:ext uri="{FF2B5EF4-FFF2-40B4-BE49-F238E27FC236}">
                    <a16:creationId xmlns:a16="http://schemas.microsoft.com/office/drawing/2014/main" id="{323590C8-4388-6238-9C40-A079E1CF85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8"/>
              <a:srcRect t="90173"/>
              <a:stretch/>
            </p:blipFill>
            <p:spPr>
              <a:xfrm>
                <a:off x="10229" y="7099537"/>
                <a:ext cx="6858000" cy="316306"/>
              </a:xfrm>
              <a:prstGeom prst="rect">
                <a:avLst/>
              </a:prstGeom>
            </p:spPr>
          </p:pic>
          <p:sp>
            <p:nvSpPr>
              <p:cNvPr id="127" name="Rectangle 126">
                <a:extLst>
                  <a:ext uri="{FF2B5EF4-FFF2-40B4-BE49-F238E27FC236}">
                    <a16:creationId xmlns:a16="http://schemas.microsoft.com/office/drawing/2014/main" id="{0A4A53A5-C15E-A01A-EB1D-2CCB06B4D451}"/>
                  </a:ext>
                </a:extLst>
              </p:cNvPr>
              <p:cNvSpPr/>
              <p:nvPr/>
            </p:nvSpPr>
            <p:spPr>
              <a:xfrm>
                <a:off x="289081" y="7123679"/>
                <a:ext cx="462221" cy="22916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8" name="Rectangle 127">
                <a:extLst>
                  <a:ext uri="{FF2B5EF4-FFF2-40B4-BE49-F238E27FC236}">
                    <a16:creationId xmlns:a16="http://schemas.microsoft.com/office/drawing/2014/main" id="{581975AD-615B-A5C8-0C9D-B13745D834A1}"/>
                  </a:ext>
                </a:extLst>
              </p:cNvPr>
              <p:cNvSpPr/>
              <p:nvPr/>
            </p:nvSpPr>
            <p:spPr>
              <a:xfrm>
                <a:off x="998679" y="7129807"/>
                <a:ext cx="768112" cy="22303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9" name="Rectangle 128">
                <a:extLst>
                  <a:ext uri="{FF2B5EF4-FFF2-40B4-BE49-F238E27FC236}">
                    <a16:creationId xmlns:a16="http://schemas.microsoft.com/office/drawing/2014/main" id="{36AD4FA1-05FF-4166-1624-18916766E606}"/>
                  </a:ext>
                </a:extLst>
              </p:cNvPr>
              <p:cNvSpPr/>
              <p:nvPr/>
            </p:nvSpPr>
            <p:spPr>
              <a:xfrm>
                <a:off x="2003126" y="7152742"/>
                <a:ext cx="682320" cy="2001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0" name="Rectangle 129">
                <a:extLst>
                  <a:ext uri="{FF2B5EF4-FFF2-40B4-BE49-F238E27FC236}">
                    <a16:creationId xmlns:a16="http://schemas.microsoft.com/office/drawing/2014/main" id="{A215B554-8BBA-ED9C-444B-9765AC641AB1}"/>
                  </a:ext>
                </a:extLst>
              </p:cNvPr>
              <p:cNvSpPr/>
              <p:nvPr/>
            </p:nvSpPr>
            <p:spPr>
              <a:xfrm>
                <a:off x="2919806" y="7152742"/>
                <a:ext cx="1388488" cy="16049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B1881AF9-C28B-5128-39F8-0D1623068AAD}"/>
                  </a:ext>
                </a:extLst>
              </p:cNvPr>
              <p:cNvSpPr/>
              <p:nvPr/>
            </p:nvSpPr>
            <p:spPr>
              <a:xfrm>
                <a:off x="4551451" y="7161604"/>
                <a:ext cx="682320" cy="20010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2" name="Rectangle 131">
                <a:extLst>
                  <a:ext uri="{FF2B5EF4-FFF2-40B4-BE49-F238E27FC236}">
                    <a16:creationId xmlns:a16="http://schemas.microsoft.com/office/drawing/2014/main" id="{E8499640-3923-24FB-0D34-F7C8BB09B592}"/>
                  </a:ext>
                </a:extLst>
              </p:cNvPr>
              <p:cNvSpPr/>
              <p:nvPr/>
            </p:nvSpPr>
            <p:spPr>
              <a:xfrm>
                <a:off x="5421401" y="7176190"/>
                <a:ext cx="1388488" cy="16049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873FE4BA-D8E5-CA53-A7D3-D04582D46F7C}"/>
                  </a:ext>
                </a:extLst>
              </p:cNvPr>
              <p:cNvSpPr txBox="1"/>
              <p:nvPr/>
            </p:nvSpPr>
            <p:spPr>
              <a:xfrm>
                <a:off x="246563" y="7122014"/>
                <a:ext cx="676718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          CD19CART             0.1 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0.1 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+ CD19CART           0.5 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0.5 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+ CD19CART </a:t>
                </a:r>
              </a:p>
            </p:txBody>
          </p:sp>
        </p:grp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034DA254-CC0F-7254-5DE7-9277B7613AB0}"/>
                </a:ext>
              </a:extLst>
            </p:cNvPr>
            <p:cNvSpPr txBox="1"/>
            <p:nvPr/>
          </p:nvSpPr>
          <p:spPr>
            <a:xfrm>
              <a:off x="4567960" y="1935061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0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9B997142-C503-4C2A-A481-20DB1FAE87A5}"/>
                </a:ext>
              </a:extLst>
            </p:cNvPr>
            <p:cNvSpPr txBox="1"/>
            <p:nvPr/>
          </p:nvSpPr>
          <p:spPr>
            <a:xfrm>
              <a:off x="4602424" y="1428277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8B2A43DA-1207-698D-C9D4-9FE2E225C555}"/>
                </a:ext>
              </a:extLst>
            </p:cNvPr>
            <p:cNvSpPr txBox="1"/>
            <p:nvPr/>
          </p:nvSpPr>
          <p:spPr>
            <a:xfrm>
              <a:off x="4434664" y="1106073"/>
              <a:ext cx="5891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2/M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177ECFF4-0BD6-6198-003F-138C28925F3B}"/>
                </a:ext>
              </a:extLst>
            </p:cNvPr>
            <p:cNvSpPr txBox="1"/>
            <p:nvPr/>
          </p:nvSpPr>
          <p:spPr>
            <a:xfrm>
              <a:off x="5834051" y="1955152"/>
              <a:ext cx="3225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0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155FD2B6-3E57-34E3-31F5-0BA83D99AAD9}"/>
                </a:ext>
              </a:extLst>
            </p:cNvPr>
            <p:cNvSpPr txBox="1"/>
            <p:nvPr/>
          </p:nvSpPr>
          <p:spPr>
            <a:xfrm>
              <a:off x="5868515" y="1458416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58B17054-9048-67EC-E51C-C7B88CAC9B9A}"/>
                </a:ext>
              </a:extLst>
            </p:cNvPr>
            <p:cNvSpPr txBox="1"/>
            <p:nvPr/>
          </p:nvSpPr>
          <p:spPr>
            <a:xfrm>
              <a:off x="5700755" y="1075924"/>
              <a:ext cx="5891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2/M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396AB854-A6C0-3CD6-22A5-CD7FB65643B3}"/>
                </a:ext>
              </a:extLst>
            </p:cNvPr>
            <p:cNvSpPr txBox="1"/>
            <p:nvPr/>
          </p:nvSpPr>
          <p:spPr>
            <a:xfrm>
              <a:off x="618599" y="3162816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ALM-6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0507B5B2-A134-072F-8A99-13D41BB5AB1E}"/>
                </a:ext>
              </a:extLst>
            </p:cNvPr>
            <p:cNvSpPr txBox="1"/>
            <p:nvPr/>
          </p:nvSpPr>
          <p:spPr>
            <a:xfrm>
              <a:off x="618599" y="5456376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ALM-6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A7A94BFD-95B3-0C2B-D44B-6D32DAD5F00A}"/>
                </a:ext>
              </a:extLst>
            </p:cNvPr>
            <p:cNvSpPr txBox="1"/>
            <p:nvPr/>
          </p:nvSpPr>
          <p:spPr>
            <a:xfrm>
              <a:off x="3120662" y="852050"/>
              <a:ext cx="7681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otal T cells</a:t>
              </a:r>
            </a:p>
          </p:txBody>
        </p:sp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3D8F1A00-E5DC-C959-C221-65295FF1E9D4}"/>
                </a:ext>
              </a:extLst>
            </p:cNvPr>
            <p:cNvSpPr/>
            <p:nvPr/>
          </p:nvSpPr>
          <p:spPr>
            <a:xfrm>
              <a:off x="3045256" y="2591601"/>
              <a:ext cx="821532" cy="4238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8" name="Rectangle 147">
              <a:extLst>
                <a:ext uri="{FF2B5EF4-FFF2-40B4-BE49-F238E27FC236}">
                  <a16:creationId xmlns:a16="http://schemas.microsoft.com/office/drawing/2014/main" id="{91F17F0A-3AB6-C6ED-1229-182A76534C31}"/>
                </a:ext>
              </a:extLst>
            </p:cNvPr>
            <p:cNvSpPr/>
            <p:nvPr/>
          </p:nvSpPr>
          <p:spPr>
            <a:xfrm>
              <a:off x="4472238" y="2591601"/>
              <a:ext cx="821532" cy="4238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F98FA500-D54C-DC8A-7484-EB2DE80D5573}"/>
                </a:ext>
              </a:extLst>
            </p:cNvPr>
            <p:cNvSpPr/>
            <p:nvPr/>
          </p:nvSpPr>
          <p:spPr>
            <a:xfrm>
              <a:off x="5719201" y="2584396"/>
              <a:ext cx="821532" cy="42383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505486D0-477F-5BDD-12B9-79CF7608A0BF}"/>
                </a:ext>
              </a:extLst>
            </p:cNvPr>
            <p:cNvSpPr txBox="1"/>
            <p:nvPr/>
          </p:nvSpPr>
          <p:spPr>
            <a:xfrm>
              <a:off x="3121728" y="2568717"/>
              <a:ext cx="7232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rux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D9936D10-5A06-CB98-900F-DA388771A432}"/>
                </a:ext>
              </a:extLst>
            </p:cNvPr>
            <p:cNvSpPr txBox="1"/>
            <p:nvPr/>
          </p:nvSpPr>
          <p:spPr>
            <a:xfrm>
              <a:off x="625906" y="4419735"/>
              <a:ext cx="14029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4    48    72    96    120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AEC166B-AA42-4206-F364-24910070CD91}"/>
                </a:ext>
              </a:extLst>
            </p:cNvPr>
            <p:cNvSpPr txBox="1"/>
            <p:nvPr/>
          </p:nvSpPr>
          <p:spPr>
            <a:xfrm>
              <a:off x="4544506" y="2568717"/>
              <a:ext cx="7232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rux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84EFDB0-62A0-31BD-6D17-AE2A171E189A}"/>
                </a:ext>
              </a:extLst>
            </p:cNvPr>
            <p:cNvSpPr txBox="1"/>
            <p:nvPr/>
          </p:nvSpPr>
          <p:spPr>
            <a:xfrm>
              <a:off x="5801349" y="2591601"/>
              <a:ext cx="7232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rux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D2606ED-00B0-E68C-4D25-486AF546CE59}"/>
                </a:ext>
              </a:extLst>
            </p:cNvPr>
            <p:cNvSpPr txBox="1"/>
            <p:nvPr/>
          </p:nvSpPr>
          <p:spPr>
            <a:xfrm>
              <a:off x="-19368" y="583328"/>
              <a:ext cx="3818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19011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194A1AE-EBC3-064C-7082-D55D0CB4492B}"/>
              </a:ext>
            </a:extLst>
          </p:cNvPr>
          <p:cNvGrpSpPr/>
          <p:nvPr/>
        </p:nvGrpSpPr>
        <p:grpSpPr>
          <a:xfrm>
            <a:off x="1534481" y="921115"/>
            <a:ext cx="3781345" cy="6317330"/>
            <a:chOff x="1534481" y="1441815"/>
            <a:chExt cx="3781345" cy="6317330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4752636-38B7-6898-A27F-088AD6EFDCE8}"/>
                </a:ext>
              </a:extLst>
            </p:cNvPr>
            <p:cNvGrpSpPr/>
            <p:nvPr/>
          </p:nvGrpSpPr>
          <p:grpSpPr>
            <a:xfrm>
              <a:off x="1534481" y="1441815"/>
              <a:ext cx="3781345" cy="3397722"/>
              <a:chOff x="1124649" y="1441815"/>
              <a:chExt cx="3781345" cy="3397722"/>
            </a:xfrm>
          </p:grpSpPr>
          <p:pic>
            <p:nvPicPr>
              <p:cNvPr id="52" name="Picture 51" descr="A graph of a bar chart&#10;&#10;Description automatically generated with medium confidence">
                <a:extLst>
                  <a:ext uri="{FF2B5EF4-FFF2-40B4-BE49-F238E27FC236}">
                    <a16:creationId xmlns:a16="http://schemas.microsoft.com/office/drawing/2014/main" id="{3AA083FF-B2BC-48F2-9A52-83A2D8739D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328" t="11393" b="16136"/>
              <a:stretch/>
            </p:blipFill>
            <p:spPr>
              <a:xfrm>
                <a:off x="1443677" y="1441815"/>
                <a:ext cx="3462317" cy="3051528"/>
              </a:xfrm>
              <a:prstGeom prst="rect">
                <a:avLst/>
              </a:prstGeom>
            </p:spPr>
          </p:pic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DEE97652-2AAB-B521-BFDD-05DC093822E1}"/>
                  </a:ext>
                </a:extLst>
              </p:cNvPr>
              <p:cNvSpPr txBox="1"/>
              <p:nvPr/>
            </p:nvSpPr>
            <p:spPr>
              <a:xfrm>
                <a:off x="1849157" y="4439427"/>
                <a:ext cx="5822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4+</a:t>
                </a:r>
              </a:p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1E671B5F-3F1E-F814-41EF-4A4F076FDB1A}"/>
                  </a:ext>
                </a:extLst>
              </p:cNvPr>
              <p:cNvSpPr txBox="1"/>
              <p:nvPr/>
            </p:nvSpPr>
            <p:spPr>
              <a:xfrm>
                <a:off x="2448701" y="4439427"/>
                <a:ext cx="79060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4+</a:t>
                </a:r>
              </a:p>
              <a:p>
                <a:pPr algn="ctr"/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0.1 </a:t>
                </a:r>
                <a:r>
                  <a:rPr lang="en-US" sz="10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816193D-2BA4-2CAB-54E7-481CCD01E8BE}"/>
                  </a:ext>
                </a:extLst>
              </p:cNvPr>
              <p:cNvSpPr txBox="1"/>
              <p:nvPr/>
            </p:nvSpPr>
            <p:spPr>
              <a:xfrm>
                <a:off x="3877098" y="4439427"/>
                <a:ext cx="79060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8+</a:t>
                </a:r>
              </a:p>
              <a:p>
                <a:pPr algn="ctr"/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0.1 </a:t>
                </a:r>
                <a:r>
                  <a:rPr lang="en-US" sz="10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7078AA7-2DBF-44E2-6B27-D144BDB8705D}"/>
                  </a:ext>
                </a:extLst>
              </p:cNvPr>
              <p:cNvSpPr txBox="1"/>
              <p:nvPr/>
            </p:nvSpPr>
            <p:spPr>
              <a:xfrm>
                <a:off x="3272012" y="4439427"/>
                <a:ext cx="58221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8+</a:t>
                </a:r>
              </a:p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8A78C61-FDF9-4C09-D3ED-F3E6E9A22BE5}"/>
                  </a:ext>
                </a:extLst>
              </p:cNvPr>
              <p:cNvSpPr txBox="1"/>
              <p:nvPr/>
            </p:nvSpPr>
            <p:spPr>
              <a:xfrm rot="16200000">
                <a:off x="261431" y="2823086"/>
                <a:ext cx="1988045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olyfunctional strength index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2796BACC-2602-C0D8-4DB9-F5E923BC00DE}"/>
                </a:ext>
              </a:extLst>
            </p:cNvPr>
            <p:cNvGrpSpPr/>
            <p:nvPr/>
          </p:nvGrpSpPr>
          <p:grpSpPr>
            <a:xfrm>
              <a:off x="1586477" y="5243520"/>
              <a:ext cx="3685046" cy="2515625"/>
              <a:chOff x="1017427" y="5243520"/>
              <a:chExt cx="3685046" cy="2515625"/>
            </a:xfrm>
          </p:grpSpPr>
          <p:sp>
            <p:nvSpPr>
              <p:cNvPr id="9" name="Text Box 2">
                <a:extLst>
                  <a:ext uri="{FF2B5EF4-FFF2-40B4-BE49-F238E27FC236}">
                    <a16:creationId xmlns:a16="http://schemas.microsoft.com/office/drawing/2014/main" id="{0DBDF31D-E310-90E1-2575-BAF4D0D5520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40156" y="5243520"/>
                <a:ext cx="3462317" cy="2515625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400"/>
                  </a:spcAft>
                </a:pPr>
                <a:r>
                  <a:rPr lang="en-US" sz="11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Effector</a:t>
                </a: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ranzyme B, IFN-</a:t>
                </a:r>
                <a:r>
                  <a:rPr lang="el-GR" sz="1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γ</a:t>
                </a:r>
                <a:r>
                  <a:rPr lang="en-US" sz="1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, MIP-1</a:t>
                </a:r>
                <a:r>
                  <a:rPr lang="el-GR" sz="1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, perforin, TNF-</a:t>
                </a:r>
                <a:r>
                  <a:rPr lang="el-GR" sz="1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1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, TNF-</a:t>
                </a:r>
                <a:r>
                  <a:rPr lang="el-GR" sz="1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β</a:t>
                </a:r>
                <a:endParaRPr lang="en-US" sz="1000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400"/>
                  </a:spcAft>
                </a:pPr>
                <a:r>
                  <a:rPr lang="en-US" sz="11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Stimulatory</a:t>
                </a: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000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M-CSF, IL-12, IL-15, IL-2, IL-21, IL-5, IL-7, IL-8, IL-9</a:t>
                </a: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400"/>
                  </a:spcAft>
                </a:pPr>
                <a:r>
                  <a:rPr lang="en-US" sz="11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hemoattractive</a:t>
                </a: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CL-11, IP-10, MIP-1</a:t>
                </a:r>
                <a:r>
                  <a:rPr lang="el-GR" sz="1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, RANTES</a:t>
                </a: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400"/>
                  </a:spcAft>
                </a:pPr>
                <a:r>
                  <a:rPr lang="en-US" sz="11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egulatory</a:t>
                </a: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L-10, IL-13, IL-22, IL-4, sCD137, sCD40L, TGF-</a:t>
                </a:r>
                <a:r>
                  <a:rPr lang="el-GR" sz="1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1</a:t>
                </a: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400"/>
                  </a:spcAft>
                </a:pPr>
                <a:r>
                  <a:rPr lang="en-US" sz="11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nflammatory</a:t>
                </a:r>
              </a:p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L-17A, IL-17F, IL-1B, MCP-1, MCP-4</a:t>
                </a:r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6DAB97B2-6AA9-4FEB-F9C5-07800511FA82}"/>
                  </a:ext>
                </a:extLst>
              </p:cNvPr>
              <p:cNvSpPr/>
              <p:nvPr/>
            </p:nvSpPr>
            <p:spPr>
              <a:xfrm>
                <a:off x="1017429" y="5306095"/>
                <a:ext cx="180305" cy="182880"/>
              </a:xfrm>
              <a:prstGeom prst="rect">
                <a:avLst/>
              </a:prstGeom>
              <a:solidFill>
                <a:srgbClr val="B4CD87"/>
              </a:solidFill>
              <a:ln>
                <a:solidFill>
                  <a:srgbClr val="FFFF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926CE3A4-C8F0-7D32-F507-EF9FC9BFA69D}"/>
                  </a:ext>
                </a:extLst>
              </p:cNvPr>
              <p:cNvSpPr/>
              <p:nvPr/>
            </p:nvSpPr>
            <p:spPr>
              <a:xfrm>
                <a:off x="1018246" y="5783434"/>
                <a:ext cx="180305" cy="182880"/>
              </a:xfrm>
              <a:prstGeom prst="rect">
                <a:avLst/>
              </a:prstGeom>
              <a:solidFill>
                <a:srgbClr val="7BD0E4"/>
              </a:solidFill>
              <a:ln>
                <a:solidFill>
                  <a:srgbClr val="7BD0E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9F32F36A-D607-7C65-8FCF-0A6A7D5337C8}"/>
                  </a:ext>
                </a:extLst>
              </p:cNvPr>
              <p:cNvSpPr/>
              <p:nvPr/>
            </p:nvSpPr>
            <p:spPr>
              <a:xfrm>
                <a:off x="1018246" y="6286531"/>
                <a:ext cx="180305" cy="182880"/>
              </a:xfrm>
              <a:prstGeom prst="rect">
                <a:avLst/>
              </a:prstGeom>
              <a:solidFill>
                <a:srgbClr val="C39BEB"/>
              </a:solidFill>
              <a:ln>
                <a:solidFill>
                  <a:srgbClr val="FFFF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139CFCED-3490-D658-02C2-CD478BF2115B}"/>
                  </a:ext>
                </a:extLst>
              </p:cNvPr>
              <p:cNvSpPr/>
              <p:nvPr/>
            </p:nvSpPr>
            <p:spPr>
              <a:xfrm>
                <a:off x="1017428" y="6776749"/>
                <a:ext cx="180305" cy="182880"/>
              </a:xfrm>
              <a:prstGeom prst="rect">
                <a:avLst/>
              </a:prstGeom>
              <a:solidFill>
                <a:srgbClr val="FFE79E"/>
              </a:solidFill>
              <a:ln>
                <a:solidFill>
                  <a:srgbClr val="FFE79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D3E4EF99-78A6-EFD0-C1DC-2A10A9A6FC49}"/>
                  </a:ext>
                </a:extLst>
              </p:cNvPr>
              <p:cNvSpPr/>
              <p:nvPr/>
            </p:nvSpPr>
            <p:spPr>
              <a:xfrm>
                <a:off x="1017427" y="7266967"/>
                <a:ext cx="180305" cy="182880"/>
              </a:xfrm>
              <a:prstGeom prst="rect">
                <a:avLst/>
              </a:prstGeom>
              <a:solidFill>
                <a:srgbClr val="F1D5D5"/>
              </a:solidFill>
              <a:ln>
                <a:solidFill>
                  <a:srgbClr val="F1D5D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30242A7C-C234-5B74-4EA3-5245F8596CB0}"/>
              </a:ext>
            </a:extLst>
          </p:cNvPr>
          <p:cNvSpPr txBox="1"/>
          <p:nvPr/>
        </p:nvSpPr>
        <p:spPr>
          <a:xfrm>
            <a:off x="43544" y="54426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14892183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BAA506-00F0-C68B-B727-A2AF2E200F8F}"/>
              </a:ext>
            </a:extLst>
          </p:cNvPr>
          <p:cNvSpPr txBox="1"/>
          <p:nvPr/>
        </p:nvSpPr>
        <p:spPr>
          <a:xfrm>
            <a:off x="43544" y="54426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D443140-8CB9-EFE6-68A5-7D0C64A2B144}"/>
              </a:ext>
            </a:extLst>
          </p:cNvPr>
          <p:cNvSpPr txBox="1"/>
          <p:nvPr/>
        </p:nvSpPr>
        <p:spPr>
          <a:xfrm>
            <a:off x="2784885" y="1182761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grpSp>
        <p:nvGrpSpPr>
          <p:cNvPr id="54" name="Group 53">
            <a:extLst>
              <a:ext uri="{FF2B5EF4-FFF2-40B4-BE49-F238E27FC236}">
                <a16:creationId xmlns:a16="http://schemas.microsoft.com/office/drawing/2014/main" id="{75631197-54CF-09FE-6A3F-B571A4DE0CBD}"/>
              </a:ext>
            </a:extLst>
          </p:cNvPr>
          <p:cNvGrpSpPr/>
          <p:nvPr/>
        </p:nvGrpSpPr>
        <p:grpSpPr>
          <a:xfrm>
            <a:off x="161347" y="575027"/>
            <a:ext cx="6737342" cy="7762151"/>
            <a:chOff x="161347" y="575027"/>
            <a:chExt cx="6737342" cy="7762151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BC5D6AE8-DB17-A891-AEC6-158F9BC2D5C6}"/>
                </a:ext>
              </a:extLst>
            </p:cNvPr>
            <p:cNvGrpSpPr/>
            <p:nvPr/>
          </p:nvGrpSpPr>
          <p:grpSpPr>
            <a:xfrm>
              <a:off x="161347" y="575027"/>
              <a:ext cx="6737342" cy="7762151"/>
              <a:chOff x="161347" y="575027"/>
              <a:chExt cx="6737342" cy="7762151"/>
            </a:xfrm>
          </p:grpSpPr>
          <p:graphicFrame>
            <p:nvGraphicFramePr>
              <p:cNvPr id="165" name="Object 164">
                <a:extLst>
                  <a:ext uri="{FF2B5EF4-FFF2-40B4-BE49-F238E27FC236}">
                    <a16:creationId xmlns:a16="http://schemas.microsoft.com/office/drawing/2014/main" id="{5C7090C2-A87A-4701-A144-223B5D498D9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62517293"/>
                  </p:ext>
                </p:extLst>
              </p:nvPr>
            </p:nvGraphicFramePr>
            <p:xfrm>
              <a:off x="389128" y="644081"/>
              <a:ext cx="3205163" cy="23145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3" imgW="8022383" imgH="5232678" progId="Prism9.Document">
                      <p:embed/>
                    </p:oleObj>
                  </mc:Choice>
                  <mc:Fallback>
                    <p:oleObj name="Prism 9" r:id="rId3" imgW="8022383" imgH="5232678" progId="Prism9.Document">
                      <p:embed/>
                      <p:pic>
                        <p:nvPicPr>
                          <p:cNvPr id="165" name="Object 164">
                            <a:extLst>
                              <a:ext uri="{FF2B5EF4-FFF2-40B4-BE49-F238E27FC236}">
                                <a16:creationId xmlns:a16="http://schemas.microsoft.com/office/drawing/2014/main" id="{5C7090C2-A87A-4701-A144-223B5D498D9E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389128" y="644081"/>
                            <a:ext cx="3205163" cy="23145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66" name="Object 165">
                <a:extLst>
                  <a:ext uri="{FF2B5EF4-FFF2-40B4-BE49-F238E27FC236}">
                    <a16:creationId xmlns:a16="http://schemas.microsoft.com/office/drawing/2014/main" id="{0E8BE359-4ED2-413A-9F7C-D97C5CBF70A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877192228"/>
                  </p:ext>
                </p:extLst>
              </p:nvPr>
            </p:nvGraphicFramePr>
            <p:xfrm>
              <a:off x="3528426" y="650368"/>
              <a:ext cx="3370263" cy="23082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5" imgW="7857801" imgH="5232678" progId="Prism9.Document">
                      <p:embed/>
                    </p:oleObj>
                  </mc:Choice>
                  <mc:Fallback>
                    <p:oleObj name="Prism 9" r:id="rId5" imgW="7857801" imgH="5232678" progId="Prism9.Document">
                      <p:embed/>
                      <p:pic>
                        <p:nvPicPr>
                          <p:cNvPr id="166" name="Object 165">
                            <a:extLst>
                              <a:ext uri="{FF2B5EF4-FFF2-40B4-BE49-F238E27FC236}">
                                <a16:creationId xmlns:a16="http://schemas.microsoft.com/office/drawing/2014/main" id="{0E8BE359-4ED2-413A-9F7C-D97C5CBF70AB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3528426" y="650368"/>
                            <a:ext cx="3370263" cy="23082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C1231965-EEEA-4296-9674-BCE365857B48}"/>
                  </a:ext>
                </a:extLst>
              </p:cNvPr>
              <p:cNvSpPr txBox="1"/>
              <p:nvPr/>
            </p:nvSpPr>
            <p:spPr>
              <a:xfrm>
                <a:off x="161347" y="5844152"/>
                <a:ext cx="19317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965823F5-D684-48FD-BD70-5BBD46B143BB}"/>
                  </a:ext>
                </a:extLst>
              </p:cNvPr>
              <p:cNvSpPr txBox="1"/>
              <p:nvPr/>
            </p:nvSpPr>
            <p:spPr>
              <a:xfrm>
                <a:off x="161347" y="575027"/>
                <a:ext cx="19317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aphicFrame>
            <p:nvGraphicFramePr>
              <p:cNvPr id="10" name="Object 9">
                <a:extLst>
                  <a:ext uri="{FF2B5EF4-FFF2-40B4-BE49-F238E27FC236}">
                    <a16:creationId xmlns:a16="http://schemas.microsoft.com/office/drawing/2014/main" id="{CFFB5410-8CB0-405C-ACAC-59B7D325382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238311645"/>
                  </p:ext>
                </p:extLst>
              </p:nvPr>
            </p:nvGraphicFramePr>
            <p:xfrm>
              <a:off x="346875" y="6311981"/>
              <a:ext cx="2886075" cy="20193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7" imgW="4916933" imgH="3443131" progId="Prism9.Document">
                      <p:embed/>
                    </p:oleObj>
                  </mc:Choice>
                  <mc:Fallback>
                    <p:oleObj name="Prism 9" r:id="rId7" imgW="4916933" imgH="3443131" progId="Prism9.Document">
                      <p:embed/>
                      <p:pic>
                        <p:nvPicPr>
                          <p:cNvPr id="10" name="Object 9">
                            <a:extLst>
                              <a:ext uri="{FF2B5EF4-FFF2-40B4-BE49-F238E27FC236}">
                                <a16:creationId xmlns:a16="http://schemas.microsoft.com/office/drawing/2014/main" id="{CFFB5410-8CB0-405C-ACAC-59B7D325382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346875" y="6311981"/>
                            <a:ext cx="2886075" cy="20193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" name="Object 10">
                <a:extLst>
                  <a:ext uri="{FF2B5EF4-FFF2-40B4-BE49-F238E27FC236}">
                    <a16:creationId xmlns:a16="http://schemas.microsoft.com/office/drawing/2014/main" id="{722F18C6-C76E-422B-B3BB-2E24BC59858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75354172"/>
                  </p:ext>
                </p:extLst>
              </p:nvPr>
            </p:nvGraphicFramePr>
            <p:xfrm>
              <a:off x="3448050" y="6318672"/>
              <a:ext cx="2935288" cy="19875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9" imgW="5031096" imgH="3411087" progId="Prism9.Document">
                      <p:embed/>
                    </p:oleObj>
                  </mc:Choice>
                  <mc:Fallback>
                    <p:oleObj name="Prism 9" r:id="rId9" imgW="5031096" imgH="3411087" progId="Prism9.Document">
                      <p:embed/>
                      <p:pic>
                        <p:nvPicPr>
                          <p:cNvPr id="11" name="Object 10">
                            <a:extLst>
                              <a:ext uri="{FF2B5EF4-FFF2-40B4-BE49-F238E27FC236}">
                                <a16:creationId xmlns:a16="http://schemas.microsoft.com/office/drawing/2014/main" id="{722F18C6-C76E-422B-B3BB-2E24BC598587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3448050" y="6318672"/>
                            <a:ext cx="2935288" cy="19875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4CEE64A-B006-476B-ABFD-7142C9AA8366}"/>
                  </a:ext>
                </a:extLst>
              </p:cNvPr>
              <p:cNvSpPr txBox="1"/>
              <p:nvPr/>
            </p:nvSpPr>
            <p:spPr>
              <a:xfrm>
                <a:off x="3324727" y="575027"/>
                <a:ext cx="19317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196AED9E-3630-448E-8AAC-AAD9F92B78FC}"/>
                  </a:ext>
                </a:extLst>
              </p:cNvPr>
              <p:cNvSpPr txBox="1"/>
              <p:nvPr/>
            </p:nvSpPr>
            <p:spPr>
              <a:xfrm>
                <a:off x="3324727" y="5844151"/>
                <a:ext cx="19317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EC0B5C47-46BB-5B69-E1BA-942EA5B59256}"/>
                  </a:ext>
                </a:extLst>
              </p:cNvPr>
              <p:cNvSpPr txBox="1"/>
              <p:nvPr/>
            </p:nvSpPr>
            <p:spPr>
              <a:xfrm rot="16200000">
                <a:off x="-112409" y="1621380"/>
                <a:ext cx="1144399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flux [p/s]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BD04CB0-9C11-FFA5-6857-11E1AA3EA2A7}"/>
                  </a:ext>
                </a:extLst>
              </p:cNvPr>
              <p:cNvSpPr txBox="1"/>
              <p:nvPr/>
            </p:nvSpPr>
            <p:spPr>
              <a:xfrm rot="16200000">
                <a:off x="3050670" y="1585605"/>
                <a:ext cx="1144399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flux [p/s]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1B5B546F-C257-2685-7FF0-7DD785CABA7A}"/>
                  </a:ext>
                </a:extLst>
              </p:cNvPr>
              <p:cNvSpPr/>
              <p:nvPr/>
            </p:nvSpPr>
            <p:spPr>
              <a:xfrm>
                <a:off x="955236" y="652726"/>
                <a:ext cx="1770692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EEE04617-49E0-0015-0C32-E2C88A7C7F64}"/>
                  </a:ext>
                </a:extLst>
              </p:cNvPr>
              <p:cNvSpPr/>
              <p:nvPr/>
            </p:nvSpPr>
            <p:spPr>
              <a:xfrm>
                <a:off x="4059536" y="710573"/>
                <a:ext cx="2209692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8F93B8D3-49A4-6DCE-439C-BEA64FCA347F}"/>
                  </a:ext>
                </a:extLst>
              </p:cNvPr>
              <p:cNvSpPr/>
              <p:nvPr/>
            </p:nvSpPr>
            <p:spPr>
              <a:xfrm>
                <a:off x="4050561" y="3363124"/>
                <a:ext cx="2209692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50F98467-934D-FC3C-B9E5-F3428AC73FE5}"/>
                  </a:ext>
                </a:extLst>
              </p:cNvPr>
              <p:cNvSpPr/>
              <p:nvPr/>
            </p:nvSpPr>
            <p:spPr>
              <a:xfrm>
                <a:off x="843176" y="5286992"/>
                <a:ext cx="2209692" cy="3077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0B413557-2769-7AE4-833F-BCE217B8D1F5}"/>
                  </a:ext>
                </a:extLst>
              </p:cNvPr>
              <p:cNvSpPr/>
              <p:nvPr/>
            </p:nvSpPr>
            <p:spPr>
              <a:xfrm>
                <a:off x="2263444" y="3734461"/>
                <a:ext cx="873627" cy="58623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5CF101BD-5930-AA3A-FC6A-5E95E3784016}"/>
                  </a:ext>
                </a:extLst>
              </p:cNvPr>
              <p:cNvSpPr/>
              <p:nvPr/>
            </p:nvSpPr>
            <p:spPr>
              <a:xfrm>
                <a:off x="5445316" y="3620822"/>
                <a:ext cx="873627" cy="58623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42C85595-EB87-0D4F-4BB6-3F6F8AC53425}"/>
                  </a:ext>
                </a:extLst>
              </p:cNvPr>
              <p:cNvSpPr txBox="1"/>
              <p:nvPr/>
            </p:nvSpPr>
            <p:spPr>
              <a:xfrm>
                <a:off x="831950" y="6430233"/>
                <a:ext cx="1113846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srgbClr val="FF77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●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vehicle</a:t>
                </a:r>
              </a:p>
              <a:p>
                <a:r>
                  <a:rPr lang="en-US" sz="700" dirty="0">
                    <a:solidFill>
                      <a:srgbClr val="008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  <a:r>
                  <a:rPr lang="en-US" sz="7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0</a:t>
                </a:r>
              </a:p>
              <a:p>
                <a:r>
                  <a:rPr lang="en-US" sz="700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7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7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61AC21B3-9ED7-25C0-09D1-17870FF7CE0A}"/>
                  </a:ext>
                </a:extLst>
              </p:cNvPr>
              <p:cNvSpPr/>
              <p:nvPr/>
            </p:nvSpPr>
            <p:spPr>
              <a:xfrm>
                <a:off x="2928180" y="1055090"/>
                <a:ext cx="627697" cy="76257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90C7D74D-6DBE-6A4E-93E3-F224A9936A31}"/>
                  </a:ext>
                </a:extLst>
              </p:cNvPr>
              <p:cNvSpPr/>
              <p:nvPr/>
            </p:nvSpPr>
            <p:spPr>
              <a:xfrm>
                <a:off x="6312064" y="1095576"/>
                <a:ext cx="551306" cy="76257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0B0EADF-E594-BAAA-48D0-76EF8951BDEA}"/>
                  </a:ext>
                </a:extLst>
              </p:cNvPr>
              <p:cNvSpPr txBox="1"/>
              <p:nvPr/>
            </p:nvSpPr>
            <p:spPr>
              <a:xfrm>
                <a:off x="3945233" y="6216717"/>
                <a:ext cx="11271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e6 TSLPRCART</a:t>
                </a:r>
              </a:p>
              <a:p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" name="Rectangle 2">
                <a:extLst>
                  <a:ext uri="{FF2B5EF4-FFF2-40B4-BE49-F238E27FC236}">
                    <a16:creationId xmlns:a16="http://schemas.microsoft.com/office/drawing/2014/main" id="{994B7600-C695-9DF8-623B-C2DD863DCCD6}"/>
                  </a:ext>
                </a:extLst>
              </p:cNvPr>
              <p:cNvSpPr/>
              <p:nvPr/>
            </p:nvSpPr>
            <p:spPr>
              <a:xfrm>
                <a:off x="856551" y="2178081"/>
                <a:ext cx="544380" cy="38404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id="{A8FEED5A-F9BB-BAF3-E81E-E55BF289ADA8}"/>
                  </a:ext>
                </a:extLst>
              </p:cNvPr>
              <p:cNvSpPr/>
              <p:nvPr/>
            </p:nvSpPr>
            <p:spPr>
              <a:xfrm>
                <a:off x="4035285" y="2178081"/>
                <a:ext cx="544380" cy="38404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48A48268-644B-8215-5E1C-E307EA690E5B}"/>
                  </a:ext>
                </a:extLst>
              </p:cNvPr>
              <p:cNvSpPr txBox="1"/>
              <p:nvPr/>
            </p:nvSpPr>
            <p:spPr>
              <a:xfrm>
                <a:off x="744767" y="6230293"/>
                <a:ext cx="11271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TSLPRCART</a:t>
                </a:r>
              </a:p>
              <a:p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01A4DEB-CEC6-1D0B-8A79-D0B4D6DDBCBC}"/>
                  </a:ext>
                </a:extLst>
              </p:cNvPr>
              <p:cNvSpPr txBox="1"/>
              <p:nvPr/>
            </p:nvSpPr>
            <p:spPr>
              <a:xfrm>
                <a:off x="795204" y="2763429"/>
                <a:ext cx="2112473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9C00AC68-6F7D-B168-2F24-4498023B075D}"/>
                  </a:ext>
                </a:extLst>
              </p:cNvPr>
              <p:cNvSpPr txBox="1"/>
              <p:nvPr/>
            </p:nvSpPr>
            <p:spPr>
              <a:xfrm>
                <a:off x="3999024" y="2763429"/>
                <a:ext cx="2237508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42F0DB05-FDE5-CD03-EB3E-4915614DBE45}"/>
                  </a:ext>
                </a:extLst>
              </p:cNvPr>
              <p:cNvSpPr txBox="1"/>
              <p:nvPr/>
            </p:nvSpPr>
            <p:spPr>
              <a:xfrm>
                <a:off x="815707" y="8075568"/>
                <a:ext cx="2112473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30E58D0-374B-10D7-7968-5433195AC600}"/>
                  </a:ext>
                </a:extLst>
              </p:cNvPr>
              <p:cNvSpPr txBox="1"/>
              <p:nvPr/>
            </p:nvSpPr>
            <p:spPr>
              <a:xfrm>
                <a:off x="3980736" y="8075568"/>
                <a:ext cx="2112473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B6A8FB03-AA3E-2D1D-C130-697C9746B69D}"/>
                  </a:ext>
                </a:extLst>
              </p:cNvPr>
              <p:cNvSpPr txBox="1"/>
              <p:nvPr/>
            </p:nvSpPr>
            <p:spPr>
              <a:xfrm rot="16200000">
                <a:off x="4915" y="7047466"/>
                <a:ext cx="886782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g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3612D03-D696-07B6-D330-7B52133FA837}"/>
                  </a:ext>
                </a:extLst>
              </p:cNvPr>
              <p:cNvSpPr txBox="1"/>
              <p:nvPr/>
            </p:nvSpPr>
            <p:spPr>
              <a:xfrm rot="16200000">
                <a:off x="3128457" y="7047466"/>
                <a:ext cx="886782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g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F86B8260-D32F-9161-7B5A-00461634698D}"/>
                  </a:ext>
                </a:extLst>
              </p:cNvPr>
              <p:cNvSpPr txBox="1"/>
              <p:nvPr/>
            </p:nvSpPr>
            <p:spPr>
              <a:xfrm>
                <a:off x="829469" y="799543"/>
                <a:ext cx="112717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UTZ5 – controls</a:t>
                </a:r>
              </a:p>
              <a:p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A9950462-2EFC-27FC-017E-C1977CE80566}"/>
                  </a:ext>
                </a:extLst>
              </p:cNvPr>
              <p:cNvSpPr txBox="1"/>
              <p:nvPr/>
            </p:nvSpPr>
            <p:spPr>
              <a:xfrm>
                <a:off x="831950" y="1858148"/>
                <a:ext cx="1119217" cy="7386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solidFill>
                      <a:srgbClr val="F95B1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●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  <a:p>
                <a:r>
                  <a:rPr lang="en-US" sz="700" dirty="0">
                    <a:solidFill>
                      <a:srgbClr val="008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︎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0</a:t>
                </a:r>
              </a:p>
              <a:p>
                <a:r>
                  <a:rPr lang="en-US" sz="700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700" dirty="0">
                    <a:solidFill>
                      <a:srgbClr val="FF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7</a:t>
                </a:r>
              </a:p>
              <a:p>
                <a:r>
                  <a:rPr lang="en-US" sz="700" dirty="0">
                    <a:solidFill>
                      <a:srgbClr val="FF93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○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UTD</a:t>
                </a:r>
              </a:p>
              <a:p>
                <a:r>
                  <a:rPr lang="en-US" sz="7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◻︎</a:t>
                </a:r>
                <a:r>
                  <a:rPr lang="en-US" sz="7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UTD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0</a:t>
                </a:r>
              </a:p>
              <a:p>
                <a:r>
                  <a:rPr lang="en-US" sz="7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△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UTD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7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F9E4CA33-B8A7-4A41-FC52-4224B47528F3}"/>
                  </a:ext>
                </a:extLst>
              </p:cNvPr>
              <p:cNvSpPr txBox="1"/>
              <p:nvPr/>
            </p:nvSpPr>
            <p:spPr>
              <a:xfrm>
                <a:off x="4004890" y="2181314"/>
                <a:ext cx="968535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solidFill>
                      <a:srgbClr val="F95B1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●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TSLPRCART</a:t>
                </a:r>
              </a:p>
              <a:p>
                <a:r>
                  <a:rPr lang="en-US" sz="700" dirty="0">
                    <a:solidFill>
                      <a:srgbClr val="008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︎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0</a:t>
                </a:r>
              </a:p>
              <a:p>
                <a:r>
                  <a:rPr lang="en-US" sz="700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700" dirty="0">
                    <a:solidFill>
                      <a:srgbClr val="FF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7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B08F0371-13B2-27C1-993E-E2E73CE316AB}"/>
                  </a:ext>
                </a:extLst>
              </p:cNvPr>
              <p:cNvSpPr txBox="1"/>
              <p:nvPr/>
            </p:nvSpPr>
            <p:spPr>
              <a:xfrm>
                <a:off x="4883597" y="2181314"/>
                <a:ext cx="1021869" cy="41549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700" dirty="0">
                    <a:solidFill>
                      <a:srgbClr val="FF93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○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e6 TSLPRCART</a:t>
                </a:r>
              </a:p>
              <a:p>
                <a:r>
                  <a:rPr lang="en-US" sz="7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◻︎</a:t>
                </a:r>
                <a:r>
                  <a:rPr lang="en-US" sz="7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0</a:t>
                </a:r>
              </a:p>
              <a:p>
                <a:r>
                  <a:rPr lang="en-US" sz="7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△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7</a:t>
                </a:r>
              </a:p>
            </p:txBody>
          </p:sp>
        </p:grpSp>
        <p:sp>
          <p:nvSpPr>
            <p:cNvPr id="41" name="Right Bracket 40">
              <a:extLst>
                <a:ext uri="{FF2B5EF4-FFF2-40B4-BE49-F238E27FC236}">
                  <a16:creationId xmlns:a16="http://schemas.microsoft.com/office/drawing/2014/main" id="{60FC8DD7-DBA1-C81F-2D2A-B6C5F9B87043}"/>
                </a:ext>
              </a:extLst>
            </p:cNvPr>
            <p:cNvSpPr/>
            <p:nvPr/>
          </p:nvSpPr>
          <p:spPr>
            <a:xfrm>
              <a:off x="2787540" y="1201245"/>
              <a:ext cx="45719" cy="164592"/>
            </a:xfrm>
            <a:prstGeom prst="righ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8B255ECA-DB9D-0763-8171-47F49B155DC1}"/>
                </a:ext>
              </a:extLst>
            </p:cNvPr>
            <p:cNvSpPr/>
            <p:nvPr/>
          </p:nvSpPr>
          <p:spPr>
            <a:xfrm>
              <a:off x="6093209" y="1346173"/>
              <a:ext cx="143323" cy="1110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338F14A1-0813-7BDC-843B-631F66AAD381}"/>
                </a:ext>
              </a:extLst>
            </p:cNvPr>
            <p:cNvSpPr txBox="1"/>
            <p:nvPr/>
          </p:nvSpPr>
          <p:spPr>
            <a:xfrm>
              <a:off x="6025437" y="1311627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8F7B92A-5335-7CB5-36F5-2F673EFC1921}"/>
                </a:ext>
              </a:extLst>
            </p:cNvPr>
            <p:cNvSpPr txBox="1"/>
            <p:nvPr/>
          </p:nvSpPr>
          <p:spPr>
            <a:xfrm>
              <a:off x="5218122" y="6434224"/>
              <a:ext cx="111663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srgbClr val="FF77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●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vehicle</a:t>
              </a:r>
            </a:p>
            <a:p>
              <a:r>
                <a:rPr lang="en-US" sz="700" dirty="0">
                  <a:solidFill>
                    <a:srgbClr val="008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■</a:t>
              </a:r>
              <a:r>
                <a:rPr lang="en-US" sz="7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ruxolitinib day 0</a:t>
              </a:r>
            </a:p>
            <a:p>
              <a:r>
                <a:rPr lang="en-US" sz="700" dirty="0">
                  <a:solidFill>
                    <a:srgbClr val="0432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▲</a:t>
              </a:r>
              <a:r>
                <a:rPr lang="en-US" sz="700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ruxolitinib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day 7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87EB199F-C707-40C0-BDEA-4A5C8A221460}"/>
                </a:ext>
              </a:extLst>
            </p:cNvPr>
            <p:cNvSpPr txBox="1"/>
            <p:nvPr/>
          </p:nvSpPr>
          <p:spPr>
            <a:xfrm>
              <a:off x="1002568" y="7660184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D61307F-DE62-223D-B3D5-EF27AD446FC9}"/>
                </a:ext>
              </a:extLst>
            </p:cNvPr>
            <p:cNvSpPr txBox="1"/>
            <p:nvPr/>
          </p:nvSpPr>
          <p:spPr>
            <a:xfrm>
              <a:off x="1728956" y="7476837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9DD9A7BA-A8BF-B4C8-252B-7FE9873211DC}"/>
                </a:ext>
              </a:extLst>
            </p:cNvPr>
            <p:cNvSpPr txBox="1"/>
            <p:nvPr/>
          </p:nvSpPr>
          <p:spPr>
            <a:xfrm>
              <a:off x="4163855" y="7580957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2034616-C95D-D671-28A3-C9E096C4DCB5}"/>
                </a:ext>
              </a:extLst>
            </p:cNvPr>
            <p:cNvSpPr txBox="1"/>
            <p:nvPr/>
          </p:nvSpPr>
          <p:spPr>
            <a:xfrm>
              <a:off x="4230477" y="6637976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79EDAF6B-E551-4744-38E6-3B56073F28C6}"/>
              </a:ext>
            </a:extLst>
          </p:cNvPr>
          <p:cNvSpPr txBox="1"/>
          <p:nvPr/>
        </p:nvSpPr>
        <p:spPr>
          <a:xfrm>
            <a:off x="161347" y="3262875"/>
            <a:ext cx="1931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53DAF5DE-89A9-FD4C-5D8B-4500F2E06EC2}"/>
              </a:ext>
            </a:extLst>
          </p:cNvPr>
          <p:cNvGrpSpPr/>
          <p:nvPr/>
        </p:nvGrpSpPr>
        <p:grpSpPr>
          <a:xfrm>
            <a:off x="360539" y="3439624"/>
            <a:ext cx="2912974" cy="2189575"/>
            <a:chOff x="1686014" y="3453918"/>
            <a:chExt cx="2912974" cy="2189575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0B61CCF2-496E-4C21-6CC8-E4C090239782}"/>
                </a:ext>
              </a:extLst>
            </p:cNvPr>
            <p:cNvGrpSpPr/>
            <p:nvPr/>
          </p:nvGrpSpPr>
          <p:grpSpPr>
            <a:xfrm>
              <a:off x="1816100" y="3596281"/>
              <a:ext cx="2782888" cy="1792288"/>
              <a:chOff x="1816100" y="3298825"/>
              <a:chExt cx="2782888" cy="1792288"/>
            </a:xfrm>
          </p:grpSpPr>
          <p:graphicFrame>
            <p:nvGraphicFramePr>
              <p:cNvPr id="17" name="Object 16">
                <a:extLst>
                  <a:ext uri="{FF2B5EF4-FFF2-40B4-BE49-F238E27FC236}">
                    <a16:creationId xmlns:a16="http://schemas.microsoft.com/office/drawing/2014/main" id="{96FDA637-40CA-9FCC-010D-B759F990C3D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93300585"/>
                  </p:ext>
                </p:extLst>
              </p:nvPr>
            </p:nvGraphicFramePr>
            <p:xfrm>
              <a:off x="1816100" y="3298825"/>
              <a:ext cx="2782888" cy="17922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1" imgW="6414017" imgH="4127580" progId="Prism10.Document">
                      <p:embed/>
                    </p:oleObj>
                  </mc:Choice>
                  <mc:Fallback>
                    <p:oleObj name="Prism 10" r:id="rId11" imgW="6414017" imgH="4127580" progId="Prism10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1816100" y="3298825"/>
                            <a:ext cx="2782888" cy="17922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16CCC70-AECA-28EF-867D-5AE59B5A9A09}"/>
                  </a:ext>
                </a:extLst>
              </p:cNvPr>
              <p:cNvSpPr txBox="1"/>
              <p:nvPr/>
            </p:nvSpPr>
            <p:spPr>
              <a:xfrm>
                <a:off x="3429000" y="4393727"/>
                <a:ext cx="1113846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srgbClr val="FF77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●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vehicle</a:t>
                </a:r>
              </a:p>
              <a:p>
                <a:r>
                  <a:rPr lang="en-US" sz="700" dirty="0">
                    <a:solidFill>
                      <a:srgbClr val="008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  <a:r>
                  <a:rPr lang="en-US" sz="7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0</a:t>
                </a:r>
              </a:p>
              <a:p>
                <a:r>
                  <a:rPr lang="en-US" sz="700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7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7</a:t>
                </a:r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FB13D1B-1C1B-6875-0BF4-7F98EF1AE7A4}"/>
                </a:ext>
              </a:extLst>
            </p:cNvPr>
            <p:cNvSpPr txBox="1"/>
            <p:nvPr/>
          </p:nvSpPr>
          <p:spPr>
            <a:xfrm rot="16200000">
              <a:off x="957449" y="4338429"/>
              <a:ext cx="1718739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45+/CD3+ T cells/</a:t>
              </a:r>
              <a:r>
                <a:rPr lang="en-US" sz="900" dirty="0">
                  <a:latin typeface="Symbol" pitchFamily="2" charset="2"/>
                  <a:cs typeface="Arial" panose="020B0604020202020204" pitchFamily="34" charset="0"/>
                </a:rPr>
                <a:t>m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 blood</a:t>
              </a:r>
            </a:p>
            <a:p>
              <a:pPr algn="ctr"/>
              <a:endParaRPr 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13BAC5F-E1C6-3F08-1659-2F4FDC38EFB2}"/>
                </a:ext>
              </a:extLst>
            </p:cNvPr>
            <p:cNvSpPr txBox="1"/>
            <p:nvPr/>
          </p:nvSpPr>
          <p:spPr>
            <a:xfrm>
              <a:off x="2177145" y="5381883"/>
              <a:ext cx="2112473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Days from TSLPRCART treatment</a:t>
              </a:r>
            </a:p>
            <a:p>
              <a:pPr algn="ctr"/>
              <a:endParaRPr 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D388C80-D1AE-3F23-3BBB-E540CCC634E6}"/>
                </a:ext>
              </a:extLst>
            </p:cNvPr>
            <p:cNvSpPr txBox="1"/>
            <p:nvPr/>
          </p:nvSpPr>
          <p:spPr>
            <a:xfrm>
              <a:off x="2077711" y="3453918"/>
              <a:ext cx="11271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UTD</a:t>
              </a:r>
            </a:p>
            <a:p>
              <a:endParaRPr 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FB74BF6D-A516-4243-2475-72456268F91B}"/>
                </a:ext>
              </a:extLst>
            </p:cNvPr>
            <p:cNvSpPr txBox="1"/>
            <p:nvPr/>
          </p:nvSpPr>
          <p:spPr>
            <a:xfrm>
              <a:off x="2567885" y="4184387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88B4FF5-3722-A4C4-A2AD-40E9260AB72E}"/>
                </a:ext>
              </a:extLst>
            </p:cNvPr>
            <p:cNvSpPr txBox="1"/>
            <p:nvPr/>
          </p:nvSpPr>
          <p:spPr>
            <a:xfrm>
              <a:off x="3687264" y="4099330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7BA8069-5199-F8BD-E483-483C8E06E24E}"/>
                </a:ext>
              </a:extLst>
            </p:cNvPr>
            <p:cNvSpPr txBox="1"/>
            <p:nvPr/>
          </p:nvSpPr>
          <p:spPr>
            <a:xfrm>
              <a:off x="3600190" y="4320406"/>
              <a:ext cx="2648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636120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531C3C0-4D5C-3E9D-01D8-FABF9C19AB22}"/>
              </a:ext>
            </a:extLst>
          </p:cNvPr>
          <p:cNvSpPr txBox="1"/>
          <p:nvPr/>
        </p:nvSpPr>
        <p:spPr>
          <a:xfrm>
            <a:off x="43544" y="54426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3F9E4F78-559A-7B96-5472-BB0371E26E10}"/>
              </a:ext>
            </a:extLst>
          </p:cNvPr>
          <p:cNvGrpSpPr/>
          <p:nvPr/>
        </p:nvGrpSpPr>
        <p:grpSpPr>
          <a:xfrm>
            <a:off x="229773" y="560830"/>
            <a:ext cx="4087893" cy="8327643"/>
            <a:chOff x="229773" y="560830"/>
            <a:chExt cx="4087893" cy="8327643"/>
          </a:xfrm>
        </p:grpSpPr>
        <p:graphicFrame>
          <p:nvGraphicFramePr>
            <p:cNvPr id="12" name="Object 11">
              <a:extLst>
                <a:ext uri="{FF2B5EF4-FFF2-40B4-BE49-F238E27FC236}">
                  <a16:creationId xmlns:a16="http://schemas.microsoft.com/office/drawing/2014/main" id="{BE7C284A-4E65-4286-89E1-7EF255AEF64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28869458"/>
                </p:ext>
              </p:extLst>
            </p:nvPr>
          </p:nvGraphicFramePr>
          <p:xfrm>
            <a:off x="730971" y="4899172"/>
            <a:ext cx="3038475" cy="188594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8757060" imgH="5040356" progId="Prism9.Document">
                    <p:embed/>
                  </p:oleObj>
                </mc:Choice>
                <mc:Fallback>
                  <p:oleObj name="Prism 9" r:id="rId3" imgW="8757060" imgH="5040356" progId="Prism9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BE7C284A-4E65-4286-89E1-7EF255AEF643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30971" y="4899172"/>
                          <a:ext cx="3038475" cy="188594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74447889-501B-60A9-5AF2-E1B861D54EFA}"/>
                </a:ext>
              </a:extLst>
            </p:cNvPr>
            <p:cNvGrpSpPr/>
            <p:nvPr/>
          </p:nvGrpSpPr>
          <p:grpSpPr>
            <a:xfrm>
              <a:off x="229773" y="4860920"/>
              <a:ext cx="3717986" cy="2007338"/>
              <a:chOff x="140873" y="5000620"/>
              <a:chExt cx="3717986" cy="2007338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E12A5801-8935-A35C-FD60-C2E9CC55F5ED}"/>
                  </a:ext>
                </a:extLst>
              </p:cNvPr>
              <p:cNvSpPr txBox="1"/>
              <p:nvPr/>
            </p:nvSpPr>
            <p:spPr>
              <a:xfrm>
                <a:off x="140873" y="5118265"/>
                <a:ext cx="20006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D5357CA9-6046-27F8-F8AA-41C92CA81932}"/>
                  </a:ext>
                </a:extLst>
              </p:cNvPr>
              <p:cNvSpPr/>
              <p:nvPr/>
            </p:nvSpPr>
            <p:spPr>
              <a:xfrm>
                <a:off x="906713" y="5000620"/>
                <a:ext cx="2041462" cy="2995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2DFF3AF-7F0D-B942-E39C-F446C830899B}"/>
                  </a:ext>
                </a:extLst>
              </p:cNvPr>
              <p:cNvSpPr txBox="1"/>
              <p:nvPr/>
            </p:nvSpPr>
            <p:spPr>
              <a:xfrm>
                <a:off x="745308" y="6761737"/>
                <a:ext cx="2112473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3E1CB238-F496-6F7F-7A72-DD0CA772A1E2}"/>
                  </a:ext>
                </a:extLst>
              </p:cNvPr>
              <p:cNvSpPr/>
              <p:nvPr/>
            </p:nvSpPr>
            <p:spPr>
              <a:xfrm>
                <a:off x="925001" y="6600523"/>
                <a:ext cx="1757998" cy="15916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C30187C-C410-6785-AA49-2D0403F7539C}"/>
                  </a:ext>
                </a:extLst>
              </p:cNvPr>
              <p:cNvSpPr txBox="1"/>
              <p:nvPr/>
            </p:nvSpPr>
            <p:spPr>
              <a:xfrm>
                <a:off x="969897" y="6568903"/>
                <a:ext cx="18004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    7   14   21   28   35   42  49   56</a:t>
                </a: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94CF6F84-F5AF-A7B6-A459-0BBF7935A00F}"/>
                  </a:ext>
                </a:extLst>
              </p:cNvPr>
              <p:cNvSpPr/>
              <p:nvPr/>
            </p:nvSpPr>
            <p:spPr>
              <a:xfrm>
                <a:off x="1049466" y="6240720"/>
                <a:ext cx="1011741" cy="3035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31173D94-925B-597B-6FBB-38DB79209834}"/>
                  </a:ext>
                </a:extLst>
              </p:cNvPr>
              <p:cNvSpPr/>
              <p:nvPr/>
            </p:nvSpPr>
            <p:spPr>
              <a:xfrm>
                <a:off x="2617691" y="5303886"/>
                <a:ext cx="1241168" cy="69958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8270BA88-5839-C1A3-2AC3-AC05BF74A812}"/>
                  </a:ext>
                </a:extLst>
              </p:cNvPr>
              <p:cNvSpPr txBox="1"/>
              <p:nvPr/>
            </p:nvSpPr>
            <p:spPr>
              <a:xfrm>
                <a:off x="1009552" y="5118265"/>
                <a:ext cx="1429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.5e6 TSLPRCART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01A0CBD0-568F-4909-BC59-E8D5329B219D}"/>
                  </a:ext>
                </a:extLst>
              </p:cNvPr>
              <p:cNvSpPr txBox="1"/>
              <p:nvPr/>
            </p:nvSpPr>
            <p:spPr>
              <a:xfrm rot="16200000">
                <a:off x="111752" y="5861160"/>
                <a:ext cx="1144399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flux [p/s]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007330D0-A113-0A9C-E2BB-17B3BCF2CA7F}"/>
                  </a:ext>
                </a:extLst>
              </p:cNvPr>
              <p:cNvSpPr txBox="1"/>
              <p:nvPr/>
            </p:nvSpPr>
            <p:spPr>
              <a:xfrm>
                <a:off x="2629021" y="5369405"/>
                <a:ext cx="1113846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solidFill>
                      <a:srgbClr val="FF77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●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vehicle</a:t>
                </a:r>
              </a:p>
              <a:p>
                <a:r>
                  <a:rPr lang="en-US" sz="800" dirty="0">
                    <a:solidFill>
                      <a:srgbClr val="008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  <a:r>
                  <a:rPr lang="en-US" sz="8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0</a:t>
                </a:r>
              </a:p>
              <a:p>
                <a:r>
                  <a:rPr lang="en-US" sz="700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8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7</a:t>
                </a:r>
              </a:p>
              <a:p>
                <a:r>
                  <a:rPr lang="en-US" sz="800" dirty="0">
                    <a:solidFill>
                      <a:srgbClr val="C61D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⬥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ruxolitinib day 14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5893FD4A-6B75-598A-7E44-45E994F931B8}"/>
                </a:ext>
              </a:extLst>
            </p:cNvPr>
            <p:cNvGrpSpPr/>
            <p:nvPr/>
          </p:nvGrpSpPr>
          <p:grpSpPr>
            <a:xfrm>
              <a:off x="229773" y="560830"/>
              <a:ext cx="4087893" cy="2030485"/>
              <a:chOff x="140873" y="560830"/>
              <a:chExt cx="4087893" cy="2030485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6429ED7-9BEB-4D94-A912-A5FEC6367016}"/>
                  </a:ext>
                </a:extLst>
              </p:cNvPr>
              <p:cNvSpPr txBox="1"/>
              <p:nvPr/>
            </p:nvSpPr>
            <p:spPr>
              <a:xfrm>
                <a:off x="140873" y="653536"/>
                <a:ext cx="200064" cy="307777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A</a:t>
                </a:r>
                <a:endParaRPr 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10" name="Object 9">
                <a:extLst>
                  <a:ext uri="{FF2B5EF4-FFF2-40B4-BE49-F238E27FC236}">
                    <a16:creationId xmlns:a16="http://schemas.microsoft.com/office/drawing/2014/main" id="{A55CEB76-9671-459B-99C2-42E386EF343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84199286"/>
                  </p:ext>
                </p:extLst>
              </p:nvPr>
            </p:nvGraphicFramePr>
            <p:xfrm>
              <a:off x="643809" y="581827"/>
              <a:ext cx="2803525" cy="19304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5" imgW="7961160" imgH="5040356" progId="Prism9.Document">
                      <p:embed/>
                    </p:oleObj>
                  </mc:Choice>
                  <mc:Fallback>
                    <p:oleObj name="Prism 9" r:id="rId5" imgW="7961160" imgH="5040356" progId="Prism9.Document">
                      <p:embed/>
                      <p:pic>
                        <p:nvPicPr>
                          <p:cNvPr id="10" name="Object 9">
                            <a:extLst>
                              <a:ext uri="{FF2B5EF4-FFF2-40B4-BE49-F238E27FC236}">
                                <a16:creationId xmlns:a16="http://schemas.microsoft.com/office/drawing/2014/main" id="{A55CEB76-9671-459B-99C2-42E386EF3432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643809" y="581827"/>
                            <a:ext cx="2803525" cy="19304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5FB122D5-6334-863E-8FB4-992097A80C96}"/>
                  </a:ext>
                </a:extLst>
              </p:cNvPr>
              <p:cNvSpPr/>
              <p:nvPr/>
            </p:nvSpPr>
            <p:spPr>
              <a:xfrm>
                <a:off x="1172256" y="560830"/>
                <a:ext cx="1380490" cy="2995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F0C3DB51-6F4B-E1A8-6E93-C5737BD6E8C9}"/>
                  </a:ext>
                </a:extLst>
              </p:cNvPr>
              <p:cNvSpPr txBox="1"/>
              <p:nvPr/>
            </p:nvSpPr>
            <p:spPr>
              <a:xfrm>
                <a:off x="752469" y="2345094"/>
                <a:ext cx="2112473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07D5A279-226F-AF3E-7679-DBF24E5B721D}"/>
                  </a:ext>
                </a:extLst>
              </p:cNvPr>
              <p:cNvSpPr/>
              <p:nvPr/>
            </p:nvSpPr>
            <p:spPr>
              <a:xfrm>
                <a:off x="913874" y="2176781"/>
                <a:ext cx="1757998" cy="15916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3C68EC8C-D4D8-6FF7-4EE4-DC29F9338BC7}"/>
                  </a:ext>
                </a:extLst>
              </p:cNvPr>
              <p:cNvSpPr txBox="1"/>
              <p:nvPr/>
            </p:nvSpPr>
            <p:spPr>
              <a:xfrm>
                <a:off x="815598" y="2162371"/>
                <a:ext cx="185820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0         7         14        21        28</a:t>
                </a:r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9F87994A-5D1A-265B-DD90-351EAB459A36}"/>
                  </a:ext>
                </a:extLst>
              </p:cNvPr>
              <p:cNvSpPr/>
              <p:nvPr/>
            </p:nvSpPr>
            <p:spPr>
              <a:xfrm>
                <a:off x="1065770" y="1756949"/>
                <a:ext cx="1486976" cy="35955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75799B95-77B5-BF00-1885-EA18DCE0C408}"/>
                  </a:ext>
                </a:extLst>
              </p:cNvPr>
              <p:cNvSpPr/>
              <p:nvPr/>
            </p:nvSpPr>
            <p:spPr>
              <a:xfrm>
                <a:off x="2664382" y="897468"/>
                <a:ext cx="1230246" cy="12521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A275681-3008-58A6-13C9-E4C3326361DB}"/>
                  </a:ext>
                </a:extLst>
              </p:cNvPr>
              <p:cNvSpPr txBox="1"/>
              <p:nvPr/>
            </p:nvSpPr>
            <p:spPr>
              <a:xfrm rot="16200000">
                <a:off x="92409" y="1426483"/>
                <a:ext cx="1144399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flux [p/s]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3BB60C8A-7CA2-62EF-FE76-8E4A3E60D3B6}"/>
                  </a:ext>
                </a:extLst>
              </p:cNvPr>
              <p:cNvSpPr txBox="1"/>
              <p:nvPr/>
            </p:nvSpPr>
            <p:spPr>
              <a:xfrm>
                <a:off x="998909" y="653536"/>
                <a:ext cx="11271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LL121 – controls 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23389E50-310C-19D7-A4DB-C8BE0D0FEB88}"/>
                  </a:ext>
                </a:extLst>
              </p:cNvPr>
              <p:cNvSpPr txBox="1"/>
              <p:nvPr/>
            </p:nvSpPr>
            <p:spPr>
              <a:xfrm>
                <a:off x="2915586" y="914649"/>
                <a:ext cx="1313180" cy="10926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solidFill>
                      <a:srgbClr val="F95B1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●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  <a:p>
                <a:r>
                  <a:rPr lang="en-US" sz="800" dirty="0">
                    <a:solidFill>
                      <a:srgbClr val="008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︎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 +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0</a:t>
                </a:r>
              </a:p>
              <a:p>
                <a:r>
                  <a:rPr lang="en-US" sz="800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800" dirty="0">
                    <a:solidFill>
                      <a:srgbClr val="FF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 +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7</a:t>
                </a:r>
              </a:p>
              <a:p>
                <a:r>
                  <a:rPr lang="en-US" sz="800" dirty="0">
                    <a:solidFill>
                      <a:srgbClr val="A914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800" dirty="0">
                    <a:solidFill>
                      <a:srgbClr val="9437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 +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14</a:t>
                </a:r>
              </a:p>
              <a:p>
                <a:r>
                  <a:rPr lang="en-US" sz="900" dirty="0">
                    <a:solidFill>
                      <a:srgbClr val="FF93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○</a:t>
                </a:r>
                <a:r>
                  <a:rPr lang="en-US" sz="800" dirty="0">
                    <a:solidFill>
                      <a:srgbClr val="FF93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UTD</a:t>
                </a:r>
              </a:p>
              <a:p>
                <a:r>
                  <a:rPr lang="en-US" sz="8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◻︎</a:t>
                </a:r>
                <a:r>
                  <a:rPr lang="en-US" sz="8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UTD +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0</a:t>
                </a:r>
              </a:p>
              <a:p>
                <a:r>
                  <a:rPr lang="en-US" sz="8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△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UTD +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7</a:t>
                </a:r>
              </a:p>
              <a:p>
                <a:r>
                  <a:rPr lang="en-US" sz="800" dirty="0">
                    <a:solidFill>
                      <a:srgbClr val="D88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◇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1e6 UTD +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14</a:t>
                </a: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F779D8D8-F784-453B-679E-C3EE49C65BD3}"/>
                </a:ext>
              </a:extLst>
            </p:cNvPr>
            <p:cNvGrpSpPr/>
            <p:nvPr/>
          </p:nvGrpSpPr>
          <p:grpSpPr>
            <a:xfrm>
              <a:off x="229773" y="6870866"/>
              <a:ext cx="3793511" cy="2017607"/>
              <a:chOff x="140873" y="6985166"/>
              <a:chExt cx="3793511" cy="2017607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57B82AC0-3D7B-5EB7-9D6C-71EA79618EA4}"/>
                  </a:ext>
                </a:extLst>
              </p:cNvPr>
              <p:cNvSpPr txBox="1"/>
              <p:nvPr/>
            </p:nvSpPr>
            <p:spPr>
              <a:xfrm>
                <a:off x="140873" y="7130938"/>
                <a:ext cx="20006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graphicFrame>
            <p:nvGraphicFramePr>
              <p:cNvPr id="52" name="Object 51">
                <a:extLst>
                  <a:ext uri="{FF2B5EF4-FFF2-40B4-BE49-F238E27FC236}">
                    <a16:creationId xmlns:a16="http://schemas.microsoft.com/office/drawing/2014/main" id="{EBB995E4-AB20-2E8B-5A76-3E6B741B0D7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59177416"/>
                  </p:ext>
                </p:extLst>
              </p:nvPr>
            </p:nvGraphicFramePr>
            <p:xfrm>
              <a:off x="710099" y="7271317"/>
              <a:ext cx="2537473" cy="15414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7" imgW="6444268" imgH="4195989" progId="Prism10.Document">
                      <p:embed/>
                    </p:oleObj>
                  </mc:Choice>
                  <mc:Fallback>
                    <p:oleObj name="Prism 10" r:id="rId7" imgW="6444268" imgH="4195989" progId="Prism10.Document">
                      <p:embed/>
                      <p:pic>
                        <p:nvPicPr>
                          <p:cNvPr id="175" name="Object 174">
                            <a:extLst>
                              <a:ext uri="{FF2B5EF4-FFF2-40B4-BE49-F238E27FC236}">
                                <a16:creationId xmlns:a16="http://schemas.microsoft.com/office/drawing/2014/main" id="{77446150-A039-4B78-AA6E-8F95A1106CE4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710099" y="7271317"/>
                            <a:ext cx="2537473" cy="15414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5D6768D6-7415-6D8F-EE51-65EC96D3FD8E}"/>
                  </a:ext>
                </a:extLst>
              </p:cNvPr>
              <p:cNvSpPr/>
              <p:nvPr/>
            </p:nvSpPr>
            <p:spPr>
              <a:xfrm>
                <a:off x="1126349" y="8344201"/>
                <a:ext cx="1362927" cy="26792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D743C9F5-98A8-20E8-80FC-55E9D349D43F}"/>
                  </a:ext>
                </a:extLst>
              </p:cNvPr>
              <p:cNvSpPr txBox="1"/>
              <p:nvPr/>
            </p:nvSpPr>
            <p:spPr>
              <a:xfrm>
                <a:off x="1181699" y="8495265"/>
                <a:ext cx="1188720" cy="91440"/>
              </a:xfrm>
              <a:prstGeom prst="rect">
                <a:avLst/>
              </a:prstGeom>
              <a:solidFill>
                <a:srgbClr val="00B050"/>
              </a:solidFill>
              <a:ln w="6350">
                <a:solidFill>
                  <a:srgbClr val="008F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/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19A8B3FD-6868-BDC7-BDAD-8B8B64495492}"/>
                  </a:ext>
                </a:extLst>
              </p:cNvPr>
              <p:cNvSpPr txBox="1"/>
              <p:nvPr/>
            </p:nvSpPr>
            <p:spPr>
              <a:xfrm>
                <a:off x="1569627" y="8373068"/>
                <a:ext cx="1188720" cy="91440"/>
              </a:xfrm>
              <a:prstGeom prst="rect">
                <a:avLst/>
              </a:prstGeom>
              <a:solidFill>
                <a:srgbClr val="0432FF"/>
              </a:solidFill>
              <a:ln w="6350">
                <a:solidFill>
                  <a:srgbClr val="008F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/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E3199C6C-EA7E-569B-1EB9-75F2975AF329}"/>
                  </a:ext>
                </a:extLst>
              </p:cNvPr>
              <p:cNvSpPr txBox="1"/>
              <p:nvPr/>
            </p:nvSpPr>
            <p:spPr>
              <a:xfrm>
                <a:off x="1975891" y="8250871"/>
                <a:ext cx="813816" cy="91440"/>
              </a:xfrm>
              <a:prstGeom prst="rect">
                <a:avLst/>
              </a:prstGeom>
              <a:solidFill>
                <a:srgbClr val="C61DFF"/>
              </a:solidFill>
              <a:ln w="6350">
                <a:solidFill>
                  <a:srgbClr val="008F00"/>
                </a:solidFill>
              </a:ln>
            </p:spPr>
            <p:txBody>
              <a:bodyPr wrap="square" rtlCol="0" anchor="ctr">
                <a:spAutoFit/>
              </a:bodyPr>
              <a:lstStyle/>
              <a:p>
                <a:pPr algn="ctr"/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9E4EB891-5BCB-77D5-031D-D7BFB3C2768F}"/>
                  </a:ext>
                </a:extLst>
              </p:cNvPr>
              <p:cNvSpPr/>
              <p:nvPr/>
            </p:nvSpPr>
            <p:spPr>
              <a:xfrm>
                <a:off x="751207" y="6985166"/>
                <a:ext cx="2634708" cy="2416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A8C2DC14-E770-0D9C-D145-C57F69B30262}"/>
                  </a:ext>
                </a:extLst>
              </p:cNvPr>
              <p:cNvSpPr txBox="1"/>
              <p:nvPr/>
            </p:nvSpPr>
            <p:spPr>
              <a:xfrm rot="16200000">
                <a:off x="-196788" y="7943472"/>
                <a:ext cx="1718740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+/CD3+ T cells/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 blood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75CD1958-854A-10CA-D932-515DCA1E1922}"/>
                  </a:ext>
                </a:extLst>
              </p:cNvPr>
              <p:cNvSpPr txBox="1"/>
              <p:nvPr/>
            </p:nvSpPr>
            <p:spPr>
              <a:xfrm>
                <a:off x="997110" y="7130938"/>
                <a:ext cx="1127176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UTD</a:t>
                </a:r>
              </a:p>
              <a:p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A08AFF94-C12D-4BB8-52FF-F831336CB98B}"/>
                  </a:ext>
                </a:extLst>
              </p:cNvPr>
              <p:cNvSpPr txBox="1"/>
              <p:nvPr/>
            </p:nvSpPr>
            <p:spPr>
              <a:xfrm>
                <a:off x="940932" y="8741163"/>
                <a:ext cx="2112473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r>
                  <a:rPr lang="en-US" sz="2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30F79555-6359-9B3F-57DA-E1888048C37B}"/>
                  </a:ext>
                </a:extLst>
              </p:cNvPr>
              <p:cNvSpPr txBox="1"/>
              <p:nvPr/>
            </p:nvSpPr>
            <p:spPr>
              <a:xfrm>
                <a:off x="2820538" y="7313613"/>
                <a:ext cx="1113846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solidFill>
                      <a:srgbClr val="FF77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●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vehicle</a:t>
                </a:r>
              </a:p>
              <a:p>
                <a:r>
                  <a:rPr lang="en-US" sz="800" dirty="0">
                    <a:solidFill>
                      <a:srgbClr val="008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  <a:r>
                  <a:rPr lang="en-US" sz="8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0</a:t>
                </a:r>
              </a:p>
              <a:p>
                <a:r>
                  <a:rPr lang="en-US" sz="700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8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7</a:t>
                </a:r>
              </a:p>
              <a:p>
                <a:r>
                  <a:rPr lang="en-US" sz="800" dirty="0">
                    <a:solidFill>
                      <a:srgbClr val="C61D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⬥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ruxolitinib day 14</a:t>
                </a:r>
              </a:p>
            </p:txBody>
          </p:sp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FD89C726-2B1F-2006-D863-4C2E588B5747}"/>
                </a:ext>
              </a:extLst>
            </p:cNvPr>
            <p:cNvGrpSpPr/>
            <p:nvPr/>
          </p:nvGrpSpPr>
          <p:grpSpPr>
            <a:xfrm>
              <a:off x="229773" y="2621938"/>
              <a:ext cx="3729064" cy="2086280"/>
              <a:chOff x="140873" y="2774338"/>
              <a:chExt cx="3729064" cy="2086280"/>
            </a:xfrm>
          </p:grpSpPr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209AFE9A-3385-67EF-655C-496C487F45FE}"/>
                  </a:ext>
                </a:extLst>
              </p:cNvPr>
              <p:cNvGrpSpPr/>
              <p:nvPr/>
            </p:nvGrpSpPr>
            <p:grpSpPr>
              <a:xfrm>
                <a:off x="140873" y="2774338"/>
                <a:ext cx="3729064" cy="2014358"/>
                <a:chOff x="140873" y="2774338"/>
                <a:chExt cx="3729064" cy="2014358"/>
              </a:xfrm>
            </p:grpSpPr>
            <p:graphicFrame>
              <p:nvGraphicFramePr>
                <p:cNvPr id="13" name="Object 12">
                  <a:extLst>
                    <a:ext uri="{FF2B5EF4-FFF2-40B4-BE49-F238E27FC236}">
                      <a16:creationId xmlns:a16="http://schemas.microsoft.com/office/drawing/2014/main" id="{BA64E114-E6B1-472D-8DBC-60AB7C8BAC05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64328680"/>
                    </p:ext>
                  </p:extLst>
                </p:nvPr>
              </p:nvGraphicFramePr>
              <p:xfrm>
                <a:off x="630554" y="2845596"/>
                <a:ext cx="2155825" cy="194310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9" r:id="rId9" imgW="6020389" imgH="5040356" progId="Prism9.Document">
                        <p:embed/>
                      </p:oleObj>
                    </mc:Choice>
                    <mc:Fallback>
                      <p:oleObj name="Prism 9" r:id="rId9" imgW="6020389" imgH="5040356" progId="Prism9.Document">
                        <p:embed/>
                        <p:pic>
                          <p:nvPicPr>
                            <p:cNvPr id="13" name="Object 12">
                              <a:extLst>
                                <a:ext uri="{FF2B5EF4-FFF2-40B4-BE49-F238E27FC236}">
                                  <a16:creationId xmlns:a16="http://schemas.microsoft.com/office/drawing/2014/main" id="{BA64E114-E6B1-472D-8DBC-60AB7C8BAC05}"/>
                                </a:ext>
                              </a:extLst>
                            </p:cNvPr>
                            <p:cNvPicPr preferRelativeResize="0"/>
                            <p:nvPr/>
                          </p:nvPicPr>
                          <p:blipFill>
                            <a:blip r:embed="rId1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30554" y="2845596"/>
                              <a:ext cx="2155825" cy="194310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" name="TextBox 1">
                  <a:extLst>
                    <a:ext uri="{FF2B5EF4-FFF2-40B4-BE49-F238E27FC236}">
                      <a16:creationId xmlns:a16="http://schemas.microsoft.com/office/drawing/2014/main" id="{590B9688-CC46-6908-1333-DF71DA15C83C}"/>
                    </a:ext>
                  </a:extLst>
                </p:cNvPr>
                <p:cNvSpPr txBox="1"/>
                <p:nvPr/>
              </p:nvSpPr>
              <p:spPr>
                <a:xfrm>
                  <a:off x="140873" y="2940496"/>
                  <a:ext cx="200064" cy="307777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6" name="Rectangle 5">
                  <a:extLst>
                    <a:ext uri="{FF2B5EF4-FFF2-40B4-BE49-F238E27FC236}">
                      <a16:creationId xmlns:a16="http://schemas.microsoft.com/office/drawing/2014/main" id="{7A56FE9F-F3AA-7002-6012-E47F68950029}"/>
                    </a:ext>
                  </a:extLst>
                </p:cNvPr>
                <p:cNvSpPr/>
                <p:nvPr/>
              </p:nvSpPr>
              <p:spPr>
                <a:xfrm>
                  <a:off x="651080" y="2774338"/>
                  <a:ext cx="2041462" cy="29952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9F70D500-F5D0-4F36-7040-0F1272DB7A3C}"/>
                    </a:ext>
                  </a:extLst>
                </p:cNvPr>
                <p:cNvSpPr/>
                <p:nvPr/>
              </p:nvSpPr>
              <p:spPr>
                <a:xfrm>
                  <a:off x="998093" y="4449949"/>
                  <a:ext cx="1757998" cy="15916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0AA685B3-E392-E7EA-7AED-DD34AA5BF302}"/>
                    </a:ext>
                  </a:extLst>
                </p:cNvPr>
                <p:cNvSpPr txBox="1"/>
                <p:nvPr/>
              </p:nvSpPr>
              <p:spPr>
                <a:xfrm>
                  <a:off x="963806" y="4415196"/>
                  <a:ext cx="180049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7   14   21   28   35   42  49   56</a:t>
                  </a:r>
                </a:p>
              </p:txBody>
            </p:sp>
            <p:sp>
              <p:nvSpPr>
                <p:cNvPr id="29" name="Rectangle 28">
                  <a:extLst>
                    <a:ext uri="{FF2B5EF4-FFF2-40B4-BE49-F238E27FC236}">
                      <a16:creationId xmlns:a16="http://schemas.microsoft.com/office/drawing/2014/main" id="{2341119D-DDBE-C270-FB03-4C41F9589C28}"/>
                    </a:ext>
                  </a:extLst>
                </p:cNvPr>
                <p:cNvSpPr/>
                <p:nvPr/>
              </p:nvSpPr>
              <p:spPr>
                <a:xfrm>
                  <a:off x="1020578" y="4031082"/>
                  <a:ext cx="1034538" cy="35817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F0B624C8-384C-1ADE-BB08-992855C6A506}"/>
                    </a:ext>
                  </a:extLst>
                </p:cNvPr>
                <p:cNvSpPr txBox="1"/>
                <p:nvPr/>
              </p:nvSpPr>
              <p:spPr>
                <a:xfrm>
                  <a:off x="985657" y="2940496"/>
                  <a:ext cx="112717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e6 TSLPRCART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4D591E8F-C18D-12FE-F99C-70C347EC2E66}"/>
                    </a:ext>
                  </a:extLst>
                </p:cNvPr>
                <p:cNvSpPr txBox="1"/>
                <p:nvPr/>
              </p:nvSpPr>
              <p:spPr>
                <a:xfrm rot="16200000">
                  <a:off x="79157" y="3701689"/>
                  <a:ext cx="1144399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flux [p/s]</a:t>
                  </a:r>
                </a:p>
              </p:txBody>
            </p:sp>
            <p:grpSp>
              <p:nvGrpSpPr>
                <p:cNvPr id="48" name="Group 47">
                  <a:extLst>
                    <a:ext uri="{FF2B5EF4-FFF2-40B4-BE49-F238E27FC236}">
                      <a16:creationId xmlns:a16="http://schemas.microsoft.com/office/drawing/2014/main" id="{1033D62C-133B-494D-F61B-B93BC02076AD}"/>
                    </a:ext>
                  </a:extLst>
                </p:cNvPr>
                <p:cNvGrpSpPr/>
                <p:nvPr/>
              </p:nvGrpSpPr>
              <p:grpSpPr>
                <a:xfrm>
                  <a:off x="2624217" y="3694536"/>
                  <a:ext cx="224742" cy="215444"/>
                  <a:chOff x="2727085" y="3758828"/>
                  <a:chExt cx="224742" cy="215444"/>
                </a:xfrm>
              </p:grpSpPr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A56472CC-5D2D-7615-06DB-49DE71F0D441}"/>
                      </a:ext>
                    </a:extLst>
                  </p:cNvPr>
                  <p:cNvSpPr txBox="1"/>
                  <p:nvPr/>
                </p:nvSpPr>
                <p:spPr>
                  <a:xfrm>
                    <a:off x="2727085" y="3758828"/>
                    <a:ext cx="22474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</a:t>
                    </a:r>
                  </a:p>
                </p:txBody>
              </p:sp>
              <p:sp>
                <p:nvSpPr>
                  <p:cNvPr id="47" name="Right Bracket 46">
                    <a:extLst>
                      <a:ext uri="{FF2B5EF4-FFF2-40B4-BE49-F238E27FC236}">
                        <a16:creationId xmlns:a16="http://schemas.microsoft.com/office/drawing/2014/main" id="{FE0068D1-290E-5E71-50DB-A06B35D29196}"/>
                      </a:ext>
                    </a:extLst>
                  </p:cNvPr>
                  <p:cNvSpPr/>
                  <p:nvPr/>
                </p:nvSpPr>
                <p:spPr>
                  <a:xfrm>
                    <a:off x="2730640" y="3775110"/>
                    <a:ext cx="45720" cy="182880"/>
                  </a:xfrm>
                  <a:prstGeom prst="rightBracke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8F01334D-A94A-C276-4556-A3697F9BB33B}"/>
                    </a:ext>
                  </a:extLst>
                </p:cNvPr>
                <p:cNvSpPr txBox="1"/>
                <p:nvPr/>
              </p:nvSpPr>
              <p:spPr>
                <a:xfrm>
                  <a:off x="2756091" y="3138070"/>
                  <a:ext cx="1113846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solidFill>
                        <a:srgbClr val="FF77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●</a:t>
                  </a: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vehicle</a:t>
                  </a:r>
                </a:p>
                <a:p>
                  <a:r>
                    <a:rPr lang="en-US" sz="800" dirty="0">
                      <a:solidFill>
                        <a:srgbClr val="008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■</a:t>
                  </a:r>
                  <a:r>
                    <a:rPr lang="en-US" sz="800" dirty="0">
                      <a:solidFill>
                        <a:schemeClr val="bg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uxolitinib day 0</a:t>
                  </a:r>
                </a:p>
                <a:p>
                  <a:r>
                    <a:rPr lang="en-US" sz="700" dirty="0">
                      <a:solidFill>
                        <a:srgbClr val="0432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▲</a:t>
                  </a:r>
                  <a:r>
                    <a:rPr lang="en-US" sz="800" dirty="0">
                      <a:solidFill>
                        <a:schemeClr val="bg1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uxolitinib day 7</a:t>
                  </a:r>
                </a:p>
                <a:p>
                  <a:r>
                    <a:rPr lang="en-US" sz="800" dirty="0">
                      <a:solidFill>
                        <a:srgbClr val="C61D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⬥</a:t>
                  </a: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ruxolitinib day 14</a:t>
                  </a:r>
                </a:p>
              </p:txBody>
            </p:sp>
          </p:grp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03E66E46-E570-1669-8545-52CFEEF7E311}"/>
                  </a:ext>
                </a:extLst>
              </p:cNvPr>
              <p:cNvSpPr txBox="1"/>
              <p:nvPr/>
            </p:nvSpPr>
            <p:spPr>
              <a:xfrm>
                <a:off x="739217" y="4614397"/>
                <a:ext cx="2112473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709591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56429ED7-9BEB-4D94-A912-A5FEC6367016}"/>
              </a:ext>
            </a:extLst>
          </p:cNvPr>
          <p:cNvSpPr txBox="1"/>
          <p:nvPr/>
        </p:nvSpPr>
        <p:spPr>
          <a:xfrm>
            <a:off x="375533" y="746312"/>
            <a:ext cx="200064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FB122D5-6334-863E-8FB4-992097A80C96}"/>
              </a:ext>
            </a:extLst>
          </p:cNvPr>
          <p:cNvSpPr/>
          <p:nvPr/>
        </p:nvSpPr>
        <p:spPr>
          <a:xfrm>
            <a:off x="2438744" y="746312"/>
            <a:ext cx="1380490" cy="2995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0BF34508-49A5-A5C3-21D7-8075E99516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533" y="900200"/>
            <a:ext cx="6100002" cy="4531071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67859B38-66AB-FAFB-50A6-C67AA02A45D8}"/>
              </a:ext>
            </a:extLst>
          </p:cNvPr>
          <p:cNvSpPr txBox="1"/>
          <p:nvPr/>
        </p:nvSpPr>
        <p:spPr>
          <a:xfrm>
            <a:off x="3427267" y="738064"/>
            <a:ext cx="200064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478BC9D-1928-9ABE-5FD9-10420BD9E54C}"/>
              </a:ext>
            </a:extLst>
          </p:cNvPr>
          <p:cNvSpPr txBox="1"/>
          <p:nvPr/>
        </p:nvSpPr>
        <p:spPr>
          <a:xfrm>
            <a:off x="378999" y="3161611"/>
            <a:ext cx="200064" cy="30777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29F92CA-8E52-A35F-6FE3-145A3BC9129B}"/>
              </a:ext>
            </a:extLst>
          </p:cNvPr>
          <p:cNvSpPr txBox="1"/>
          <p:nvPr/>
        </p:nvSpPr>
        <p:spPr>
          <a:xfrm>
            <a:off x="43544" y="54426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6135D39-1BB2-9B14-3BC7-D4C0381243CA}"/>
              </a:ext>
            </a:extLst>
          </p:cNvPr>
          <p:cNvSpPr/>
          <p:nvPr/>
        </p:nvSpPr>
        <p:spPr>
          <a:xfrm>
            <a:off x="4138522" y="1026504"/>
            <a:ext cx="1338469" cy="3720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89BB5A6-852B-B55B-AAFC-0DF099CA4267}"/>
              </a:ext>
            </a:extLst>
          </p:cNvPr>
          <p:cNvSpPr/>
          <p:nvPr/>
        </p:nvSpPr>
        <p:spPr>
          <a:xfrm>
            <a:off x="1100275" y="900200"/>
            <a:ext cx="1338469" cy="3720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59B2158-FAE2-BFC4-F2E0-93236195B78D}"/>
              </a:ext>
            </a:extLst>
          </p:cNvPr>
          <p:cNvSpPr/>
          <p:nvPr/>
        </p:nvSpPr>
        <p:spPr>
          <a:xfrm>
            <a:off x="1155387" y="3315499"/>
            <a:ext cx="1338469" cy="3720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2666465-FA50-40F0-B4B0-BFE081B019B8}"/>
              </a:ext>
            </a:extLst>
          </p:cNvPr>
          <p:cNvSpPr txBox="1"/>
          <p:nvPr/>
        </p:nvSpPr>
        <p:spPr>
          <a:xfrm rot="16200000">
            <a:off x="138328" y="4294198"/>
            <a:ext cx="76815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D25 MF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ECAE8E8-E22C-2CA6-0EE8-904DE6F5E757}"/>
              </a:ext>
            </a:extLst>
          </p:cNvPr>
          <p:cNvSpPr txBox="1"/>
          <p:nvPr/>
        </p:nvSpPr>
        <p:spPr>
          <a:xfrm rot="16200000">
            <a:off x="141859" y="2010111"/>
            <a:ext cx="79060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FN-</a:t>
            </a:r>
            <a:r>
              <a:rPr lang="el-GR" sz="10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γ</a:t>
            </a:r>
            <a:r>
              <a:rPr lang="en-US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F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5FAB601-BDA6-826D-B6D6-6804FBEA76D7}"/>
              </a:ext>
            </a:extLst>
          </p:cNvPr>
          <p:cNvSpPr txBox="1"/>
          <p:nvPr/>
        </p:nvSpPr>
        <p:spPr>
          <a:xfrm rot="16200000">
            <a:off x="3216021" y="2014932"/>
            <a:ext cx="696024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L-2</a:t>
            </a:r>
            <a:r>
              <a:rPr lang="en-US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FI</a:t>
            </a:r>
          </a:p>
        </p:txBody>
      </p:sp>
    </p:spTree>
    <p:extLst>
      <p:ext uri="{BB962C8B-B14F-4D97-AF65-F5344CB8AC3E}">
        <p14:creationId xmlns:p14="http://schemas.microsoft.com/office/powerpoint/2010/main" val="4281299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C3946704-5CFC-D66B-3B57-B42CEC994719}"/>
              </a:ext>
            </a:extLst>
          </p:cNvPr>
          <p:cNvSpPr txBox="1"/>
          <p:nvPr/>
        </p:nvSpPr>
        <p:spPr>
          <a:xfrm>
            <a:off x="43544" y="54426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grpSp>
        <p:nvGrpSpPr>
          <p:cNvPr id="64" name="Group 63">
            <a:extLst>
              <a:ext uri="{FF2B5EF4-FFF2-40B4-BE49-F238E27FC236}">
                <a16:creationId xmlns:a16="http://schemas.microsoft.com/office/drawing/2014/main" id="{5ECE4D04-0266-181A-7BE4-BCF98C548315}"/>
              </a:ext>
            </a:extLst>
          </p:cNvPr>
          <p:cNvGrpSpPr/>
          <p:nvPr/>
        </p:nvGrpSpPr>
        <p:grpSpPr>
          <a:xfrm>
            <a:off x="185778" y="494041"/>
            <a:ext cx="6630863" cy="4891404"/>
            <a:chOff x="185778" y="494041"/>
            <a:chExt cx="6630863" cy="4891404"/>
          </a:xfrm>
        </p:grpSpPr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486D666F-DE20-1A4F-14DB-326FBEB86C23}"/>
                </a:ext>
              </a:extLst>
            </p:cNvPr>
            <p:cNvGrpSpPr/>
            <p:nvPr/>
          </p:nvGrpSpPr>
          <p:grpSpPr>
            <a:xfrm>
              <a:off x="185778" y="494041"/>
              <a:ext cx="6630863" cy="4891404"/>
              <a:chOff x="185778" y="494041"/>
              <a:chExt cx="6630863" cy="4891404"/>
            </a:xfrm>
          </p:grpSpPr>
          <p:graphicFrame>
            <p:nvGraphicFramePr>
              <p:cNvPr id="3" name="Object 2">
                <a:extLst>
                  <a:ext uri="{FF2B5EF4-FFF2-40B4-BE49-F238E27FC236}">
                    <a16:creationId xmlns:a16="http://schemas.microsoft.com/office/drawing/2014/main" id="{DAC0A877-6F12-479A-A008-87BFB00BB0A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66026057"/>
                  </p:ext>
                </p:extLst>
              </p:nvPr>
            </p:nvGraphicFramePr>
            <p:xfrm>
              <a:off x="420624" y="634625"/>
              <a:ext cx="3532188" cy="20939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3" imgW="7929468" imgH="4702171" progId="Prism9.Document">
                      <p:embed/>
                    </p:oleObj>
                  </mc:Choice>
                  <mc:Fallback>
                    <p:oleObj name="Prism 9" r:id="rId3" imgW="7929468" imgH="4702171" progId="Prism9.Document">
                      <p:embed/>
                      <p:pic>
                        <p:nvPicPr>
                          <p:cNvPr id="3" name="Object 2">
                            <a:extLst>
                              <a:ext uri="{FF2B5EF4-FFF2-40B4-BE49-F238E27FC236}">
                                <a16:creationId xmlns:a16="http://schemas.microsoft.com/office/drawing/2014/main" id="{DAC0A877-6F12-479A-A008-87BFB00BB0A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420624" y="634625"/>
                            <a:ext cx="3532188" cy="209391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A28E450F-857F-4876-97A1-24D010B98943}"/>
                  </a:ext>
                </a:extLst>
              </p:cNvPr>
              <p:cNvSpPr txBox="1"/>
              <p:nvPr/>
            </p:nvSpPr>
            <p:spPr>
              <a:xfrm>
                <a:off x="185778" y="494041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B3B913EB-00DC-431B-ABAB-4CE285889209}"/>
                  </a:ext>
                </a:extLst>
              </p:cNvPr>
              <p:cNvSpPr txBox="1"/>
              <p:nvPr/>
            </p:nvSpPr>
            <p:spPr>
              <a:xfrm>
                <a:off x="3063666" y="494041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4E368D38-7028-7F76-231C-33E5D6949B12}"/>
                  </a:ext>
                </a:extLst>
              </p:cNvPr>
              <p:cNvSpPr/>
              <p:nvPr/>
            </p:nvSpPr>
            <p:spPr>
              <a:xfrm>
                <a:off x="859536" y="679807"/>
                <a:ext cx="1828800" cy="24402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4194B8E-A53A-F99B-D310-E0DAB21FABC7}"/>
                  </a:ext>
                </a:extLst>
              </p:cNvPr>
              <p:cNvSpPr txBox="1"/>
              <p:nvPr/>
            </p:nvSpPr>
            <p:spPr>
              <a:xfrm>
                <a:off x="969264" y="826883"/>
                <a:ext cx="1446878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S-ALL515 – controls 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56A6FD40-C8B1-A5AB-2BF8-D2A7DABBA842}"/>
                  </a:ext>
                </a:extLst>
              </p:cNvPr>
              <p:cNvSpPr/>
              <p:nvPr/>
            </p:nvSpPr>
            <p:spPr>
              <a:xfrm>
                <a:off x="2882903" y="897761"/>
                <a:ext cx="1020861" cy="124348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0151C076-92A8-4CB9-D8C4-357A51F04882}"/>
                  </a:ext>
                </a:extLst>
              </p:cNvPr>
              <p:cNvSpPr/>
              <p:nvPr/>
            </p:nvSpPr>
            <p:spPr>
              <a:xfrm>
                <a:off x="3658409" y="634625"/>
                <a:ext cx="2323309" cy="28920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CDB3627-39FC-933B-271D-24A4BFB8608E}"/>
                  </a:ext>
                </a:extLst>
              </p:cNvPr>
              <p:cNvSpPr txBox="1"/>
              <p:nvPr/>
            </p:nvSpPr>
            <p:spPr>
              <a:xfrm rot="16200000">
                <a:off x="-252730" y="1551779"/>
                <a:ext cx="1545865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10+/CD19+ </a:t>
                </a:r>
              </a:p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LL cells/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 blood</a:t>
                </a:r>
              </a:p>
            </p:txBody>
          </p:sp>
          <p:graphicFrame>
            <p:nvGraphicFramePr>
              <p:cNvPr id="28" name="Object 27">
                <a:extLst>
                  <a:ext uri="{FF2B5EF4-FFF2-40B4-BE49-F238E27FC236}">
                    <a16:creationId xmlns:a16="http://schemas.microsoft.com/office/drawing/2014/main" id="{A8F2FCCD-9400-8AB8-6DF5-7E27E64455F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04919475"/>
                  </p:ext>
                </p:extLst>
              </p:nvPr>
            </p:nvGraphicFramePr>
            <p:xfrm>
              <a:off x="3313811" y="589794"/>
              <a:ext cx="3321050" cy="22018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5" imgW="6322543" imgH="4189672" progId="Prism9.Document">
                      <p:embed/>
                    </p:oleObj>
                  </mc:Choice>
                  <mc:Fallback>
                    <p:oleObj name="Prism 9" r:id="rId5" imgW="6322543" imgH="4189672" progId="Prism9.Document">
                      <p:embed/>
                      <p:pic>
                        <p:nvPicPr>
                          <p:cNvPr id="25" name="Object 24">
                            <a:extLst>
                              <a:ext uri="{FF2B5EF4-FFF2-40B4-BE49-F238E27FC236}">
                                <a16:creationId xmlns:a16="http://schemas.microsoft.com/office/drawing/2014/main" id="{CC211F01-0190-3E35-DCB4-C8941D19BFB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3313811" y="589794"/>
                            <a:ext cx="3321050" cy="22018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7C53AA54-3EBB-ADB0-5B64-F58C23DF7FEC}"/>
                  </a:ext>
                </a:extLst>
              </p:cNvPr>
              <p:cNvSpPr/>
              <p:nvPr/>
            </p:nvSpPr>
            <p:spPr>
              <a:xfrm>
                <a:off x="3678942" y="645456"/>
                <a:ext cx="2090921" cy="24402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31169575-CA55-313F-6560-D4D1FE143E35}"/>
                  </a:ext>
                </a:extLst>
              </p:cNvPr>
              <p:cNvSpPr txBox="1"/>
              <p:nvPr/>
            </p:nvSpPr>
            <p:spPr>
              <a:xfrm>
                <a:off x="3870131" y="826883"/>
                <a:ext cx="1820798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S-ALL515 – TSLPRCART </a:t>
                </a:r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6139BC05-0089-6C32-0047-85DE50C2A9B7}"/>
                  </a:ext>
                </a:extLst>
              </p:cNvPr>
              <p:cNvSpPr/>
              <p:nvPr/>
            </p:nvSpPr>
            <p:spPr>
              <a:xfrm>
                <a:off x="3311961" y="826883"/>
                <a:ext cx="211465" cy="164625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3A6C0A5F-C077-392B-550C-ECD5C1AEDC28}"/>
                  </a:ext>
                </a:extLst>
              </p:cNvPr>
              <p:cNvSpPr txBox="1"/>
              <p:nvPr/>
            </p:nvSpPr>
            <p:spPr>
              <a:xfrm rot="16200000">
                <a:off x="2430158" y="1484581"/>
                <a:ext cx="1881900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10+/CD19+ </a:t>
                </a:r>
              </a:p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LL cells/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L blood</a:t>
                </a:r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0F64BC90-9EE6-81B7-E3A7-F8B98D5BFD8F}"/>
                  </a:ext>
                </a:extLst>
              </p:cNvPr>
              <p:cNvSpPr/>
              <p:nvPr/>
            </p:nvSpPr>
            <p:spPr>
              <a:xfrm>
                <a:off x="2688034" y="3622854"/>
                <a:ext cx="1020861" cy="124348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aphicFrame>
            <p:nvGraphicFramePr>
              <p:cNvPr id="36" name="Object 35">
                <a:extLst>
                  <a:ext uri="{FF2B5EF4-FFF2-40B4-BE49-F238E27FC236}">
                    <a16:creationId xmlns:a16="http://schemas.microsoft.com/office/drawing/2014/main" id="{BEA7371D-11A0-9980-B7BC-89E94AECA7A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6705191"/>
                  </p:ext>
                </p:extLst>
              </p:nvPr>
            </p:nvGraphicFramePr>
            <p:xfrm>
              <a:off x="394255" y="3122496"/>
              <a:ext cx="3346450" cy="22129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7" imgW="6368280" imgH="4208040" progId="Prism9.Document">
                      <p:embed/>
                    </p:oleObj>
                  </mc:Choice>
                  <mc:Fallback>
                    <p:oleObj name="Prism 9" r:id="rId7" imgW="6368280" imgH="4208040" progId="Prism9.Document">
                      <p:embed/>
                      <p:pic>
                        <p:nvPicPr>
                          <p:cNvPr id="14" name="Object 13">
                            <a:extLst>
                              <a:ext uri="{FF2B5EF4-FFF2-40B4-BE49-F238E27FC236}">
                                <a16:creationId xmlns:a16="http://schemas.microsoft.com/office/drawing/2014/main" id="{365770AB-8158-4D95-A698-DAC738CCAB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394255" y="3122496"/>
                            <a:ext cx="3346450" cy="22129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DC9C6847-5CE9-DB07-0647-11254848D6E3}"/>
                  </a:ext>
                </a:extLst>
              </p:cNvPr>
              <p:cNvSpPr txBox="1"/>
              <p:nvPr/>
            </p:nvSpPr>
            <p:spPr>
              <a:xfrm>
                <a:off x="185778" y="2978025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12609CD8-AC25-5DCB-1208-EBF499CB02B9}"/>
                  </a:ext>
                </a:extLst>
              </p:cNvPr>
              <p:cNvSpPr txBox="1"/>
              <p:nvPr/>
            </p:nvSpPr>
            <p:spPr>
              <a:xfrm>
                <a:off x="3063666" y="2978025"/>
                <a:ext cx="31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0DB9A9C9-04A2-86B1-91A1-5FFAF7D3FED5}"/>
                  </a:ext>
                </a:extLst>
              </p:cNvPr>
              <p:cNvSpPr/>
              <p:nvPr/>
            </p:nvSpPr>
            <p:spPr>
              <a:xfrm>
                <a:off x="2688033" y="3534804"/>
                <a:ext cx="1215731" cy="133153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060076DE-4C0D-1E1D-5BB8-D24B06FAE6B4}"/>
                  </a:ext>
                </a:extLst>
              </p:cNvPr>
              <p:cNvSpPr/>
              <p:nvPr/>
            </p:nvSpPr>
            <p:spPr>
              <a:xfrm>
                <a:off x="1295709" y="3167800"/>
                <a:ext cx="962376" cy="33368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703CD179-5C87-D697-837E-587C1800A506}"/>
                  </a:ext>
                </a:extLst>
              </p:cNvPr>
              <p:cNvSpPr txBox="1"/>
              <p:nvPr/>
            </p:nvSpPr>
            <p:spPr>
              <a:xfrm rot="16200000">
                <a:off x="22951" y="4113789"/>
                <a:ext cx="886781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FN-</a:t>
                </a:r>
                <a:r>
                  <a:rPr lang="en-US" sz="900" dirty="0">
                    <a:latin typeface="Symbol" pitchFamily="2" charset="2"/>
                    <a:cs typeface="Arial" panose="020B0604020202020204" pitchFamily="34" charset="0"/>
                  </a:rPr>
                  <a:t>g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  <a:p>
                <a:pPr algn="ctr"/>
                <a:endParaRPr lang="en-US" sz="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725BD080-1581-D449-1539-EE0081D3DD63}"/>
                  </a:ext>
                </a:extLst>
              </p:cNvPr>
              <p:cNvSpPr txBox="1"/>
              <p:nvPr/>
            </p:nvSpPr>
            <p:spPr>
              <a:xfrm>
                <a:off x="733854" y="2553488"/>
                <a:ext cx="2112473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r>
                  <a:rPr lang="en-US" sz="2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2391E660-DB52-00E3-B010-3997AFD13767}"/>
                  </a:ext>
                </a:extLst>
              </p:cNvPr>
              <p:cNvSpPr txBox="1"/>
              <p:nvPr/>
            </p:nvSpPr>
            <p:spPr>
              <a:xfrm>
                <a:off x="3659933" y="2553488"/>
                <a:ext cx="2112473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r>
                  <a:rPr lang="en-US" sz="2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</a:p>
            </p:txBody>
          </p:sp>
          <p:graphicFrame>
            <p:nvGraphicFramePr>
              <p:cNvPr id="46" name="Object 45">
                <a:extLst>
                  <a:ext uri="{FF2B5EF4-FFF2-40B4-BE49-F238E27FC236}">
                    <a16:creationId xmlns:a16="http://schemas.microsoft.com/office/drawing/2014/main" id="{BD2BA1BE-4C52-4BFF-BCFC-CE8E53299722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016988924"/>
                  </p:ext>
                </p:extLst>
              </p:nvPr>
            </p:nvGraphicFramePr>
            <p:xfrm>
              <a:off x="3472747" y="3266831"/>
              <a:ext cx="2633663" cy="168116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9" imgW="6339109" imgH="4249097" progId="Prism9.Document">
                      <p:embed/>
                    </p:oleObj>
                  </mc:Choice>
                  <mc:Fallback>
                    <p:oleObj name="Prism 9" r:id="rId9" imgW="6339109" imgH="4249097" progId="Prism9.Document">
                      <p:embed/>
                      <p:pic>
                        <p:nvPicPr>
                          <p:cNvPr id="6" name="Object 5">
                            <a:extLst>
                              <a:ext uri="{FF2B5EF4-FFF2-40B4-BE49-F238E27FC236}">
                                <a16:creationId xmlns:a16="http://schemas.microsoft.com/office/drawing/2014/main" id="{BB6B7128-0DF7-454A-8950-C31226659AD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3472747" y="3266831"/>
                            <a:ext cx="2633663" cy="168116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135E50DE-6ED6-709F-84A8-D2A0C0DD77E7}"/>
                  </a:ext>
                </a:extLst>
              </p:cNvPr>
              <p:cNvSpPr txBox="1"/>
              <p:nvPr/>
            </p:nvSpPr>
            <p:spPr>
              <a:xfrm>
                <a:off x="727527" y="5123835"/>
                <a:ext cx="2112473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 from TSLPRCART treatment</a:t>
                </a:r>
              </a:p>
              <a:p>
                <a:pPr algn="ctr"/>
                <a:r>
                  <a:rPr lang="en-US" sz="2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DE8EE569-C721-6826-919B-F68EE27A0EF7}"/>
                  </a:ext>
                </a:extLst>
              </p:cNvPr>
              <p:cNvSpPr txBox="1"/>
              <p:nvPr/>
            </p:nvSpPr>
            <p:spPr>
              <a:xfrm rot="16200000">
                <a:off x="2658904" y="4032113"/>
                <a:ext cx="1731513" cy="2923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D4+/CD8+ T cell ratio</a:t>
                </a:r>
              </a:p>
              <a:p>
                <a:pPr algn="ctr"/>
                <a:endParaRPr lang="en-US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5E7F8776-8260-9CFE-C7B3-2B028EB9E813}"/>
                  </a:ext>
                </a:extLst>
              </p:cNvPr>
              <p:cNvSpPr/>
              <p:nvPr/>
            </p:nvSpPr>
            <p:spPr>
              <a:xfrm>
                <a:off x="5600910" y="1025892"/>
                <a:ext cx="1215731" cy="133153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D025A41F-1DAC-6A27-762A-6CD0D81B0CF9}"/>
                  </a:ext>
                </a:extLst>
              </p:cNvPr>
              <p:cNvSpPr txBox="1"/>
              <p:nvPr/>
            </p:nvSpPr>
            <p:spPr>
              <a:xfrm>
                <a:off x="5658175" y="1000629"/>
                <a:ext cx="1043876" cy="954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solidFill>
                      <a:srgbClr val="F95B1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●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SLPRCART 1e6</a:t>
                </a:r>
              </a:p>
              <a:p>
                <a:r>
                  <a:rPr lang="en-US" sz="700" dirty="0">
                    <a:solidFill>
                      <a:srgbClr val="008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︎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0</a:t>
                </a:r>
              </a:p>
              <a:p>
                <a:r>
                  <a:rPr lang="en-US" sz="700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700" dirty="0">
                    <a:solidFill>
                      <a:srgbClr val="FF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7</a:t>
                </a:r>
              </a:p>
              <a:p>
                <a:r>
                  <a:rPr lang="en-US" sz="700" dirty="0">
                    <a:solidFill>
                      <a:srgbClr val="A914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700" dirty="0">
                    <a:solidFill>
                      <a:srgbClr val="9437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14</a:t>
                </a:r>
              </a:p>
              <a:p>
                <a:r>
                  <a:rPr lang="en-US" sz="700" dirty="0">
                    <a:solidFill>
                      <a:srgbClr val="FF93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○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SLPRCART 2.5e6</a:t>
                </a:r>
              </a:p>
              <a:p>
                <a:r>
                  <a:rPr lang="en-US" sz="7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◻︎</a:t>
                </a:r>
                <a:r>
                  <a:rPr lang="en-US" sz="7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.5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0</a:t>
                </a:r>
              </a:p>
              <a:p>
                <a:r>
                  <a:rPr lang="en-US" sz="7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△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.5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7</a:t>
                </a:r>
              </a:p>
              <a:p>
                <a:r>
                  <a:rPr lang="en-US" sz="700" dirty="0">
                    <a:solidFill>
                      <a:srgbClr val="D88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◇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2.5e6 + 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ux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day 14</a:t>
                </a:r>
              </a:p>
            </p:txBody>
          </p:sp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F12CDC88-B497-F332-7710-5FDAD9E3219F}"/>
                  </a:ext>
                </a:extLst>
              </p:cNvPr>
              <p:cNvSpPr/>
              <p:nvPr/>
            </p:nvSpPr>
            <p:spPr>
              <a:xfrm>
                <a:off x="5487465" y="3335928"/>
                <a:ext cx="761577" cy="63062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CDE6422C-9F73-F19C-FDC3-59D020DA1BE8}"/>
                  </a:ext>
                </a:extLst>
              </p:cNvPr>
              <p:cNvSpPr txBox="1"/>
              <p:nvPr/>
            </p:nvSpPr>
            <p:spPr>
              <a:xfrm>
                <a:off x="5658175" y="3418000"/>
                <a:ext cx="1113846" cy="52322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solidFill>
                      <a:srgbClr val="FF77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●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vehicle</a:t>
                </a:r>
              </a:p>
              <a:p>
                <a:r>
                  <a:rPr lang="en-US" sz="700" dirty="0">
                    <a:solidFill>
                      <a:srgbClr val="008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■</a:t>
                </a:r>
                <a:r>
                  <a:rPr lang="en-US" sz="7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0</a:t>
                </a:r>
              </a:p>
              <a:p>
                <a:r>
                  <a:rPr lang="en-US" sz="700" dirty="0">
                    <a:solidFill>
                      <a:srgbClr val="0432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▲</a:t>
                </a:r>
                <a:r>
                  <a:rPr lang="en-US" sz="700" dirty="0">
                    <a:solidFill>
                      <a:schemeClr val="bg1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uxolitinib day 7</a:t>
                </a:r>
              </a:p>
              <a:p>
                <a:r>
                  <a:rPr lang="en-US" sz="700" dirty="0">
                    <a:solidFill>
                      <a:srgbClr val="C61D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⬥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ruxolitinib day 14</a:t>
                </a:r>
              </a:p>
            </p:txBody>
          </p:sp>
        </p:grp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82DF72D7-87C5-A26D-133C-9332F466F3BA}"/>
                </a:ext>
              </a:extLst>
            </p:cNvPr>
            <p:cNvSpPr/>
            <p:nvPr/>
          </p:nvSpPr>
          <p:spPr>
            <a:xfrm>
              <a:off x="1538344" y="1867121"/>
              <a:ext cx="1161152" cy="4708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1" name="Rectangle 60">
            <a:extLst>
              <a:ext uri="{FF2B5EF4-FFF2-40B4-BE49-F238E27FC236}">
                <a16:creationId xmlns:a16="http://schemas.microsoft.com/office/drawing/2014/main" id="{D8EB328F-80A7-E072-D7B0-DCE7918EADA9}"/>
              </a:ext>
            </a:extLst>
          </p:cNvPr>
          <p:cNvSpPr/>
          <p:nvPr/>
        </p:nvSpPr>
        <p:spPr>
          <a:xfrm>
            <a:off x="1261948" y="2093236"/>
            <a:ext cx="302648" cy="2442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9181285D-8289-7BA4-5B41-C8A4F3519DE5}"/>
              </a:ext>
            </a:extLst>
          </p:cNvPr>
          <p:cNvSpPr/>
          <p:nvPr/>
        </p:nvSpPr>
        <p:spPr>
          <a:xfrm>
            <a:off x="1091653" y="2224555"/>
            <a:ext cx="302648" cy="918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408B4A4-C2AB-1C19-2488-249E0AE6E858}"/>
              </a:ext>
            </a:extLst>
          </p:cNvPr>
          <p:cNvSpPr txBox="1"/>
          <p:nvPr/>
        </p:nvSpPr>
        <p:spPr>
          <a:xfrm>
            <a:off x="941273" y="3461698"/>
            <a:ext cx="104387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rgbClr val="F95B1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●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SLPRCART 1e6</a:t>
            </a:r>
          </a:p>
          <a:p>
            <a:r>
              <a:rPr lang="en-US" sz="700" dirty="0">
                <a:solidFill>
                  <a:srgbClr val="008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︎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e6 +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rux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day 0</a:t>
            </a:r>
          </a:p>
          <a:p>
            <a:r>
              <a:rPr lang="en-US" sz="700" dirty="0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▲</a:t>
            </a:r>
            <a:r>
              <a:rPr lang="en-US" sz="700" dirty="0">
                <a:solidFill>
                  <a:srgbClr val="FF99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e6 +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rux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day 7</a:t>
            </a:r>
          </a:p>
          <a:p>
            <a:r>
              <a:rPr lang="en-US" sz="700" dirty="0">
                <a:solidFill>
                  <a:srgbClr val="A914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▲</a:t>
            </a:r>
            <a:r>
              <a:rPr lang="en-US" sz="700" dirty="0">
                <a:solidFill>
                  <a:srgbClr val="9437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e6 +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rux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day 14</a:t>
            </a:r>
          </a:p>
          <a:p>
            <a:r>
              <a:rPr lang="en-US" sz="700" dirty="0">
                <a:solidFill>
                  <a:srgbClr val="FF93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○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SLPRCART 2.5e6</a:t>
            </a:r>
          </a:p>
          <a:p>
            <a:r>
              <a:rPr lang="en-US" sz="7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◻︎</a:t>
            </a:r>
            <a:r>
              <a:rPr lang="en-US" sz="7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5e6 +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rux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day 0</a:t>
            </a:r>
          </a:p>
          <a:p>
            <a:r>
              <a:rPr lang="en-US" sz="7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△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.5e6 +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rux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day 7</a:t>
            </a:r>
          </a:p>
          <a:p>
            <a:r>
              <a:rPr lang="en-US" sz="700" dirty="0">
                <a:solidFill>
                  <a:srgbClr val="D88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◇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2.5e6 +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rux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day 1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220FF38-FEB4-FECC-4EEF-0D487C8CB803}"/>
              </a:ext>
            </a:extLst>
          </p:cNvPr>
          <p:cNvSpPr txBox="1"/>
          <p:nvPr/>
        </p:nvSpPr>
        <p:spPr>
          <a:xfrm>
            <a:off x="1051601" y="4694228"/>
            <a:ext cx="373820" cy="250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560"/>
              </a:lnSpc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** </a:t>
            </a:r>
          </a:p>
          <a:p>
            <a:pPr>
              <a:lnSpc>
                <a:spcPts val="560"/>
              </a:lnSpc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31590495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48E9748-70A4-2F0A-F76E-866CB62F55CC}"/>
              </a:ext>
            </a:extLst>
          </p:cNvPr>
          <p:cNvSpPr txBox="1"/>
          <p:nvPr/>
        </p:nvSpPr>
        <p:spPr>
          <a:xfrm>
            <a:off x="43544" y="54426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C5060BD-3752-7E32-9BAE-48053D7771A7}"/>
              </a:ext>
            </a:extLst>
          </p:cNvPr>
          <p:cNvGrpSpPr/>
          <p:nvPr/>
        </p:nvGrpSpPr>
        <p:grpSpPr>
          <a:xfrm>
            <a:off x="46257" y="456829"/>
            <a:ext cx="6867525" cy="8217466"/>
            <a:chOff x="46257" y="456829"/>
            <a:chExt cx="6867525" cy="8217466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DF8F33F-9171-1B60-54CC-EF2034BA6C94}"/>
                </a:ext>
              </a:extLst>
            </p:cNvPr>
            <p:cNvSpPr txBox="1"/>
            <p:nvPr/>
          </p:nvSpPr>
          <p:spPr>
            <a:xfrm>
              <a:off x="69615" y="456829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DE2C6772-EBE1-0906-206C-F69894A8E81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90205009"/>
                </p:ext>
              </p:extLst>
            </p:nvPr>
          </p:nvGraphicFramePr>
          <p:xfrm>
            <a:off x="46257" y="696035"/>
            <a:ext cx="6867525" cy="61690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" imgW="6340549" imgH="5698826" progId="Prism10.Document">
                    <p:embed/>
                  </p:oleObj>
                </mc:Choice>
                <mc:Fallback>
                  <p:oleObj name="Prism 10" r:id="rId3" imgW="6340549" imgH="5698826" progId="Prism10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DE2C6772-EBE1-0906-206C-F69894A8E81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6257" y="696035"/>
                          <a:ext cx="6867525" cy="61690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C30FEF3-8C53-698E-1ABB-F9676591E48D}"/>
                </a:ext>
              </a:extLst>
            </p:cNvPr>
            <p:cNvSpPr txBox="1"/>
            <p:nvPr/>
          </p:nvSpPr>
          <p:spPr>
            <a:xfrm>
              <a:off x="69615" y="3710622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97B3B42-F174-288F-E76C-A45EBD080D5E}"/>
                </a:ext>
              </a:extLst>
            </p:cNvPr>
            <p:cNvSpPr txBox="1"/>
            <p:nvPr/>
          </p:nvSpPr>
          <p:spPr>
            <a:xfrm>
              <a:off x="69615" y="6936170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CF1A0753-B36A-CF26-FA98-44FFD66F2BD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6067684"/>
                </p:ext>
              </p:extLst>
            </p:nvPr>
          </p:nvGraphicFramePr>
          <p:xfrm>
            <a:off x="161925" y="7162995"/>
            <a:ext cx="6292850" cy="15113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5" imgW="6293372" imgH="1511838" progId="Prism10.Document">
                    <p:embed/>
                  </p:oleObj>
                </mc:Choice>
                <mc:Fallback>
                  <p:oleObj name="Prism 10" r:id="rId5" imgW="6293372" imgH="1511838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CF1A0753-B36A-CF26-FA98-44FFD66F2BD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61925" y="7162995"/>
                          <a:ext cx="6292850" cy="15113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243BD1D-6A3B-E043-F29A-7AB2A89C77DD}"/>
                </a:ext>
              </a:extLst>
            </p:cNvPr>
            <p:cNvSpPr txBox="1"/>
            <p:nvPr/>
          </p:nvSpPr>
          <p:spPr>
            <a:xfrm>
              <a:off x="2707511" y="487607"/>
              <a:ext cx="9914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19CART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E01588B-4E64-A95F-6D1D-E6D1A2D0614E}"/>
                </a:ext>
              </a:extLst>
            </p:cNvPr>
            <p:cNvSpPr txBox="1"/>
            <p:nvPr/>
          </p:nvSpPr>
          <p:spPr>
            <a:xfrm>
              <a:off x="2668243" y="3741400"/>
              <a:ext cx="10967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SLPRCART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D8C38D4-A1F1-6895-DEF1-AFCB6E0266C2}"/>
                </a:ext>
              </a:extLst>
            </p:cNvPr>
            <p:cNvSpPr txBox="1"/>
            <p:nvPr/>
          </p:nvSpPr>
          <p:spPr>
            <a:xfrm>
              <a:off x="330731" y="7210084"/>
              <a:ext cx="138691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SLPRCART + MUTZ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7E3C4E7-B0AA-8B56-1E63-AA4F26AB40D0}"/>
                </a:ext>
              </a:extLst>
            </p:cNvPr>
            <p:cNvSpPr txBox="1"/>
            <p:nvPr/>
          </p:nvSpPr>
          <p:spPr>
            <a:xfrm>
              <a:off x="5103896" y="7210084"/>
              <a:ext cx="132921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SLPRCART + TVA-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7DCB0C4-BE73-503A-3B40-8338FAF6C9A7}"/>
                </a:ext>
              </a:extLst>
            </p:cNvPr>
            <p:cNvSpPr txBox="1"/>
            <p:nvPr/>
          </p:nvSpPr>
          <p:spPr>
            <a:xfrm>
              <a:off x="3437815" y="7210084"/>
              <a:ext cx="125226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19CART + TVA-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575F01C-C358-E8D5-3129-BAD994B84BBF}"/>
                </a:ext>
              </a:extLst>
            </p:cNvPr>
            <p:cNvSpPr txBox="1"/>
            <p:nvPr/>
          </p:nvSpPr>
          <p:spPr>
            <a:xfrm>
              <a:off x="1759845" y="7210084"/>
              <a:ext cx="134844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D19CART + NALM-6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B2D7CE3-FBAD-056A-22B6-89AD2C775404}"/>
                </a:ext>
              </a:extLst>
            </p:cNvPr>
            <p:cNvSpPr txBox="1"/>
            <p:nvPr/>
          </p:nvSpPr>
          <p:spPr>
            <a:xfrm>
              <a:off x="6217495" y="1186766"/>
              <a:ext cx="675185" cy="44627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-) beads</a:t>
              </a:r>
            </a:p>
            <a:p>
              <a:pPr>
                <a:spcAft>
                  <a:spcPts val="600"/>
                </a:spcAft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+) beads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B69522E-65DC-CC01-120D-BB7C5E693252}"/>
                </a:ext>
              </a:extLst>
            </p:cNvPr>
            <p:cNvSpPr txBox="1"/>
            <p:nvPr/>
          </p:nvSpPr>
          <p:spPr>
            <a:xfrm>
              <a:off x="6217495" y="4405134"/>
              <a:ext cx="675185" cy="44627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spcAft>
                  <a:spcPts val="600"/>
                </a:spcAft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-) beads</a:t>
              </a:r>
            </a:p>
            <a:p>
              <a:pPr>
                <a:spcAft>
                  <a:spcPts val="600"/>
                </a:spcAft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+) bead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0071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15</TotalTime>
  <Words>829</Words>
  <Application>Microsoft Macintosh PowerPoint</Application>
  <PresentationFormat>On-screen Show (4:3)</PresentationFormat>
  <Paragraphs>245</Paragraphs>
  <Slides>7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Office Theme</vt:lpstr>
      <vt:lpstr>Prism 9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sian, Sarah</dc:creator>
  <cp:lastModifiedBy>sarah k tasian, md</cp:lastModifiedBy>
  <cp:revision>462</cp:revision>
  <cp:lastPrinted>2023-05-18T15:16:05Z</cp:lastPrinted>
  <dcterms:created xsi:type="dcterms:W3CDTF">2021-07-02T22:20:30Z</dcterms:created>
  <dcterms:modified xsi:type="dcterms:W3CDTF">2024-11-05T21:49:14Z</dcterms:modified>
</cp:coreProperties>
</file>